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hartEx1.xml" ContentType="application/vnd.ms-office.chartex+xml"/>
  <Override PartName="/ppt/charts/chartEx2.xml" ContentType="application/vnd.ms-office.chartex+xml"/>
  <Override PartName="/ppt/charts/chartEx3.xml" ContentType="application/vnd.ms-office.chartex+xml"/>
  <Override PartName="/ppt/charts/chartEx4.xml" ContentType="application/vnd.ms-office.chartex+xml"/>
  <Override PartName="/ppt/charts/chartEx5.xml" ContentType="application/vnd.ms-office.chartex+xml"/>
  <Override PartName="/ppt/charts/chartEx6.xml" ContentType="application/vnd.ms-office.chartex+xml"/>
  <Override PartName="/ppt/charts/chartEx7.xml" ContentType="application/vnd.ms-office.chartex+xml"/>
  <Override PartName="/ppt/charts/chartEx8.xml" ContentType="application/vnd.ms-office.chartex+xml"/>
  <Override PartName="/ppt/charts/chartEx9.xml" ContentType="application/vnd.ms-office.chartex+xml"/>
  <Override PartName="/ppt/charts/chartEx10.xml" ContentType="application/vnd.ms-office.chartex+xml"/>
  <Override PartName="/ppt/charts/chartEx11.xml" ContentType="application/vnd.ms-office.chartex+xml"/>
  <Override PartName="/ppt/charts/chartEx12.xml" ContentType="application/vnd.ms-office.chartex+xml"/>
  <Override PartName="/ppt/charts/chartEx13.xml" ContentType="application/vnd.ms-office.chartex+xml"/>
  <Override PartName="/ppt/charts/chartEx14.xml" ContentType="application/vnd.ms-office.chartex+xml"/>
  <Override PartName="/ppt/charts/chartEx15.xml" ContentType="application/vnd.ms-office.chartex+xml"/>
  <Override PartName="/ppt/charts/chartEx16.xml" ContentType="application/vnd.ms-office.chartex+xml"/>
  <Override PartName="/ppt/charts/chartEx17.xml" ContentType="application/vnd.ms-office.chartex+xml"/>
  <Override PartName="/ppt/charts/chartEx18.xml" ContentType="application/vnd.ms-office.chartex+xml"/>
  <Override PartName="/ppt/charts/chartEx19.xml" ContentType="application/vnd.ms-office.chartex+xml"/>
  <Override PartName="/ppt/charts/chartEx20.xml" ContentType="application/vnd.ms-office.chartex+xml"/>
  <Override PartName="/ppt/charts/chartEx21.xml" ContentType="application/vnd.ms-office.chartex+xml"/>
  <Override PartName="/ppt/charts/chartEx22.xml" ContentType="application/vnd.ms-office.chartex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  <Override PartName="/ppt/charts/colors4.xml" ContentType="application/vnd.ms-office.chartcolorstyle+xml"/>
  <Override PartName="/ppt/charts/style4.xml" ContentType="application/vnd.ms-office.chartstyle+xml"/>
  <Override PartName="/ppt/charts/colors5.xml" ContentType="application/vnd.ms-office.chartcolorstyle+xml"/>
  <Override PartName="/ppt/charts/style5.xml" ContentType="application/vnd.ms-office.chartstyle+xml"/>
  <Override PartName="/ppt/charts/colors6.xml" ContentType="application/vnd.ms-office.chartcolorstyle+xml"/>
  <Override PartName="/ppt/charts/style6.xml" ContentType="application/vnd.ms-office.chartstyle+xml"/>
  <Override PartName="/ppt/charts/colors7.xml" ContentType="application/vnd.ms-office.chartcolorstyle+xml"/>
  <Override PartName="/ppt/charts/style7.xml" ContentType="application/vnd.ms-office.chartstyle+xml"/>
  <Override PartName="/ppt/charts/colors8.xml" ContentType="application/vnd.ms-office.chartcolorstyle+xml"/>
  <Override PartName="/ppt/charts/style8.xml" ContentType="application/vnd.ms-office.chartstyle+xml"/>
  <Override PartName="/ppt/charts/colors9.xml" ContentType="application/vnd.ms-office.chartcolorstyle+xml"/>
  <Override PartName="/ppt/charts/style9.xml" ContentType="application/vnd.ms-office.chartstyle+xml"/>
  <Override PartName="/ppt/charts/colors10.xml" ContentType="application/vnd.ms-office.chartcolorstyle+xml"/>
  <Override PartName="/ppt/charts/style10.xml" ContentType="application/vnd.ms-office.chartstyle+xml"/>
  <Override PartName="/ppt/charts/colors11.xml" ContentType="application/vnd.ms-office.chartcolorstyle+xml"/>
  <Override PartName="/ppt/charts/style11.xml" ContentType="application/vnd.ms-office.chartstyle+xml"/>
  <Override PartName="/ppt/charts/colors12.xml" ContentType="application/vnd.ms-office.chartcolorstyle+xml"/>
  <Override PartName="/ppt/charts/style12.xml" ContentType="application/vnd.ms-office.chartstyle+xml"/>
  <Override PartName="/ppt/charts/colors13.xml" ContentType="application/vnd.ms-office.chartcolorstyle+xml"/>
  <Override PartName="/ppt/charts/style13.xml" ContentType="application/vnd.ms-office.chartstyle+xml"/>
  <Override PartName="/ppt/charts/colors14.xml" ContentType="application/vnd.ms-office.chartcolorstyle+xml"/>
  <Override PartName="/ppt/charts/style14.xml" ContentType="application/vnd.ms-office.chartstyle+xml"/>
  <Override PartName="/ppt/charts/colors15.xml" ContentType="application/vnd.ms-office.chartcolorstyle+xml"/>
  <Override PartName="/ppt/charts/style15.xml" ContentType="application/vnd.ms-office.chartstyle+xml"/>
  <Override PartName="/ppt/charts/colors16.xml" ContentType="application/vnd.ms-office.chartcolorstyle+xml"/>
  <Override PartName="/ppt/charts/style16.xml" ContentType="application/vnd.ms-office.chartstyle+xml"/>
  <Override PartName="/ppt/charts/colors17.xml" ContentType="application/vnd.ms-office.chartcolorstyle+xml"/>
  <Override PartName="/ppt/charts/style17.xml" ContentType="application/vnd.ms-office.chartstyle+xml"/>
  <Override PartName="/ppt/charts/colors18.xml" ContentType="application/vnd.ms-office.chartcolorstyle+xml"/>
  <Override PartName="/ppt/charts/style18.xml" ContentType="application/vnd.ms-office.chartstyle+xml"/>
  <Override PartName="/ppt/charts/colors19.xml" ContentType="application/vnd.ms-office.chartcolorstyle+xml"/>
  <Override PartName="/ppt/charts/style19.xml" ContentType="application/vnd.ms-office.chartstyle+xml"/>
  <Override PartName="/ppt/charts/colors20.xml" ContentType="application/vnd.ms-office.chartcolorstyle+xml"/>
  <Override PartName="/ppt/charts/style20.xml" ContentType="application/vnd.ms-office.chartstyle+xml"/>
  <Override PartName="/ppt/charts/colors21.xml" ContentType="application/vnd.ms-office.chartcolorstyle+xml"/>
  <Override PartName="/ppt/charts/style21.xml" ContentType="application/vnd.ms-office.chartstyle+xml"/>
  <Override PartName="/ppt/charts/colors22.xml" ContentType="application/vnd.ms-office.chartcolorstyle+xml"/>
  <Override PartName="/ppt/charts/style2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7" r:id="rId2"/>
    <p:sldId id="258" r:id="rId3"/>
    <p:sldId id="260" r:id="rId4"/>
    <p:sldId id="259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934" autoAdjust="0"/>
    <p:restoredTop sz="94660"/>
  </p:normalViewPr>
  <p:slideViewPr>
    <p:cSldViewPr snapToGrid="0">
      <p:cViewPr>
        <p:scale>
          <a:sx n="90" d="100"/>
          <a:sy n="90" d="100"/>
        </p:scale>
        <p:origin x="-1500" y="-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E:\&#1057;&#1090;&#1072;&#1090;&#1100;&#1103;_&#1072;&#1085;&#1075;&#1083;_&#1074;&#1086;&#1089;&#1087;&#1072;&#1083;&#1077;&#1085;&#1080;&#1077;_2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10.xml.rels><?xml version="1.0" encoding="UTF-8" standalone="yes"?>
<Relationships xmlns="http://schemas.openxmlformats.org/package/2006/relationships"><Relationship Id="rId3" Type="http://schemas.microsoft.com/office/2011/relationships/chartColorStyle" Target="colors10.xml"/><Relationship Id="rId2" Type="http://schemas.microsoft.com/office/2011/relationships/chartStyle" Target="style10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11.xml.rels><?xml version="1.0" encoding="UTF-8" standalone="yes"?>
<Relationships xmlns="http://schemas.openxmlformats.org/package/2006/relationships"><Relationship Id="rId3" Type="http://schemas.microsoft.com/office/2011/relationships/chartColorStyle" Target="colors11.xml"/><Relationship Id="rId2" Type="http://schemas.microsoft.com/office/2011/relationships/chartStyle" Target="style11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12.xml.rels><?xml version="1.0" encoding="UTF-8" standalone="yes"?>
<Relationships xmlns="http://schemas.openxmlformats.org/package/2006/relationships"><Relationship Id="rId3" Type="http://schemas.microsoft.com/office/2011/relationships/chartColorStyle" Target="colors12.xml"/><Relationship Id="rId2" Type="http://schemas.microsoft.com/office/2011/relationships/chartStyle" Target="style12.xml"/><Relationship Id="rId1" Type="http://schemas.openxmlformats.org/officeDocument/2006/relationships/oleObject" Target="file:///E:\&#1057;&#1090;&#1072;&#1090;&#1100;&#1103;_&#1072;&#1085;&#1075;&#1083;_&#1074;&#1086;&#1089;&#1087;&#1072;&#1083;&#1077;&#1085;&#1080;&#1077;_2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13.xml.rels><?xml version="1.0" encoding="UTF-8" standalone="yes"?>
<Relationships xmlns="http://schemas.openxmlformats.org/package/2006/relationships"><Relationship Id="rId3" Type="http://schemas.microsoft.com/office/2011/relationships/chartColorStyle" Target="colors13.xml"/><Relationship Id="rId2" Type="http://schemas.microsoft.com/office/2011/relationships/chartStyle" Target="style13.xml"/><Relationship Id="rId1" Type="http://schemas.openxmlformats.org/officeDocument/2006/relationships/oleObject" Target="file:///E:\&#1057;&#1090;&#1072;&#1090;&#1100;&#1103;_&#1072;&#1085;&#1075;&#1083;_&#1074;&#1086;&#1089;&#1087;&#1072;&#1083;&#1077;&#1085;&#1080;&#1077;_2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14.xml.rels><?xml version="1.0" encoding="UTF-8" standalone="yes"?>
<Relationships xmlns="http://schemas.openxmlformats.org/package/2006/relationships"><Relationship Id="rId3" Type="http://schemas.microsoft.com/office/2011/relationships/chartColorStyle" Target="colors14.xml"/><Relationship Id="rId2" Type="http://schemas.microsoft.com/office/2011/relationships/chartStyle" Target="style14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15.xml.rels><?xml version="1.0" encoding="UTF-8" standalone="yes"?>
<Relationships xmlns="http://schemas.openxmlformats.org/package/2006/relationships"><Relationship Id="rId3" Type="http://schemas.microsoft.com/office/2011/relationships/chartColorStyle" Target="colors15.xml"/><Relationship Id="rId2" Type="http://schemas.microsoft.com/office/2011/relationships/chartStyle" Target="style15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16.xml.rels><?xml version="1.0" encoding="UTF-8" standalone="yes"?>
<Relationships xmlns="http://schemas.openxmlformats.org/package/2006/relationships"><Relationship Id="rId3" Type="http://schemas.microsoft.com/office/2011/relationships/chartColorStyle" Target="colors16.xml"/><Relationship Id="rId2" Type="http://schemas.microsoft.com/office/2011/relationships/chartStyle" Target="style16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17.xml.rels><?xml version="1.0" encoding="UTF-8" standalone="yes"?>
<Relationships xmlns="http://schemas.openxmlformats.org/package/2006/relationships"><Relationship Id="rId3" Type="http://schemas.microsoft.com/office/2011/relationships/chartColorStyle" Target="colors17.xml"/><Relationship Id="rId2" Type="http://schemas.microsoft.com/office/2011/relationships/chartStyle" Target="style17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18.xml.rels><?xml version="1.0" encoding="UTF-8" standalone="yes"?>
<Relationships xmlns="http://schemas.openxmlformats.org/package/2006/relationships"><Relationship Id="rId3" Type="http://schemas.microsoft.com/office/2011/relationships/chartColorStyle" Target="colors18.xml"/><Relationship Id="rId2" Type="http://schemas.microsoft.com/office/2011/relationships/chartStyle" Target="style18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19.xml.rels><?xml version="1.0" encoding="UTF-8" standalone="yes"?>
<Relationships xmlns="http://schemas.openxmlformats.org/package/2006/relationships"><Relationship Id="rId3" Type="http://schemas.microsoft.com/office/2011/relationships/chartColorStyle" Target="colors19.xml"/><Relationship Id="rId2" Type="http://schemas.microsoft.com/office/2011/relationships/chartStyle" Target="style19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E:\&#1057;&#1090;&#1072;&#1090;&#1100;&#1103;_&#1072;&#1085;&#1075;&#1083;_&#1074;&#1086;&#1089;&#1087;&#1072;&#1083;&#1077;&#1085;&#1080;&#1077;_2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20.xml.rels><?xml version="1.0" encoding="UTF-8" standalone="yes"?>
<Relationships xmlns="http://schemas.openxmlformats.org/package/2006/relationships"><Relationship Id="rId3" Type="http://schemas.microsoft.com/office/2011/relationships/chartColorStyle" Target="colors20.xml"/><Relationship Id="rId2" Type="http://schemas.microsoft.com/office/2011/relationships/chartStyle" Target="style20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21.xml.rels><?xml version="1.0" encoding="UTF-8" standalone="yes"?>
<Relationships xmlns="http://schemas.openxmlformats.org/package/2006/relationships"><Relationship Id="rId3" Type="http://schemas.microsoft.com/office/2011/relationships/chartColorStyle" Target="colors21.xml"/><Relationship Id="rId2" Type="http://schemas.microsoft.com/office/2011/relationships/chartStyle" Target="style21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22.xml.rels><?xml version="1.0" encoding="UTF-8" standalone="yes"?>
<Relationships xmlns="http://schemas.openxmlformats.org/package/2006/relationships"><Relationship Id="rId3" Type="http://schemas.microsoft.com/office/2011/relationships/chartColorStyle" Target="colors22.xml"/><Relationship Id="rId2" Type="http://schemas.microsoft.com/office/2011/relationships/chartStyle" Target="style22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E:\&#1057;&#1090;&#1072;&#1090;&#1100;&#1103;_&#1072;&#1085;&#1075;&#1083;_&#1074;&#1086;&#1089;&#1087;&#1072;&#1083;&#1077;&#1085;&#1080;&#1077;_2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E:\&#1057;&#1090;&#1072;&#1090;&#1100;&#1103;_&#1072;&#1085;&#1075;&#1083;_&#1074;&#1086;&#1089;&#1087;&#1072;&#1083;&#1077;&#1085;&#1080;&#1077;_2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file:///E:\&#1057;&#1090;&#1072;&#1090;&#1100;&#1103;_&#1072;&#1085;&#1075;&#1083;_&#1074;&#1086;&#1089;&#1087;&#1072;&#1083;&#1077;&#1085;&#1080;&#1077;_2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file:///E:\&#1057;&#1090;&#1072;&#1090;&#1100;&#1103;_&#1072;&#1085;&#1075;&#1083;_&#1074;&#1086;&#1089;&#1087;&#1072;&#1083;&#1077;&#1085;&#1080;&#1077;_2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7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microsoft.com/office/2011/relationships/chartStyle" Target="style7.xml"/><Relationship Id="rId1" Type="http://schemas.openxmlformats.org/officeDocument/2006/relationships/oleObject" Target="file:///E:\&#1057;&#1090;&#1072;&#1090;&#1100;&#1103;_&#1072;&#1085;&#1075;&#1083;_&#1074;&#1086;&#1089;&#1087;&#1072;&#1083;&#1077;&#1085;&#1080;&#1077;_2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8.xml.rels><?xml version="1.0" encoding="UTF-8" standalone="yes"?>
<Relationships xmlns="http://schemas.openxmlformats.org/package/2006/relationships"><Relationship Id="rId3" Type="http://schemas.microsoft.com/office/2011/relationships/chartColorStyle" Target="colors8.xml"/><Relationship Id="rId2" Type="http://schemas.microsoft.com/office/2011/relationships/chartStyle" Target="style8.xml"/><Relationship Id="rId1" Type="http://schemas.openxmlformats.org/officeDocument/2006/relationships/oleObject" Target="file:///E:\&#1057;&#1090;&#1072;&#1090;&#1100;&#1103;_&#1072;&#1085;&#1075;&#1083;_&#1074;&#1086;&#1089;&#1087;&#1072;&#1083;&#1077;&#1085;&#1080;&#1077;_2\&#1057;&#1090;&#1072;&#1090;&#1080;&#1089;&#1090;&#1080;&#1082;&#1072;_20.06.23\&#1073;&#1080;&#1086;&#1084;&#1072;&#1088;&#1082;&#1077;&#1088;&#1099;+&#1076;&#1077;&#1083;&#1100;&#1090;&#1099;.xlsx" TargetMode="External"/></Relationships>
</file>

<file path=ppt/charts/_rels/chartEx9.xml.rels><?xml version="1.0" encoding="UTF-8" standalone="yes"?>
<Relationships xmlns="http://schemas.openxmlformats.org/package/2006/relationships"><Relationship Id="rId3" Type="http://schemas.microsoft.com/office/2011/relationships/chartColorStyle" Target="colors9.xml"/><Relationship Id="rId2" Type="http://schemas.microsoft.com/office/2011/relationships/chartStyle" Target="style9.xml"/><Relationship Id="rId1" Type="http://schemas.openxmlformats.org/officeDocument/2006/relationships/oleObject" Target="file:///F:\&#1057;&#1090;&#1072;&#1090;&#1100;&#1103;_&#1072;&#1085;&#1075;&#1083;_\&#1057;&#1090;&#1072;&#1090;&#1080;&#1089;&#1090;&#1080;&#1082;&#1072;_20.06.23\&#1073;&#1080;&#1086;&#1084;&#1072;&#1088;&#1082;&#1077;&#1088;&#1099;+&#1076;&#1077;&#1083;&#1100;&#1090;&#1099;.xlsx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54:$B$72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C$54:$C$72</cx:f>
        <cx:lvl ptCount="19" formatCode="Основной">
          <cx:pt idx="0">96.900000000000006</cx:pt>
          <cx:pt idx="1">171</cx:pt>
          <cx:pt idx="2">161</cx:pt>
          <cx:pt idx="3">210.69999999999999</cx:pt>
          <cx:pt idx="4">184.69999999999999</cx:pt>
          <cx:pt idx="7">192.90000000000001</cx:pt>
          <cx:pt idx="8">221.30000000000001</cx:pt>
          <cx:pt idx="9">231.40000000000001</cx:pt>
          <cx:pt idx="10">275.60000000000002</cx:pt>
          <cx:pt idx="11">267</cx:pt>
          <cx:pt idx="14">38.399999999999999</cx:pt>
          <cx:pt idx="15">144.69999999999999</cx:pt>
          <cx:pt idx="16">84</cx:pt>
          <cx:pt idx="17">113.7</cx:pt>
          <cx:pt idx="18">135.40000000000001</cx:pt>
        </cx:lvl>
      </cx:numDim>
    </cx:data>
    <cx:data id="1">
      <cx:strDim type="cat">
        <cx:f>Лист2!$B$54:$B$72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D$54:$D$72</cx:f>
        <cx:lvl ptCount="19" formatCode="Основной">
          <cx:pt idx="0">193.80000000000001</cx:pt>
          <cx:pt idx="1">154.90000000000001</cx:pt>
          <cx:pt idx="2">152.90000000000001</cx:pt>
          <cx:pt idx="3">110.2</cx:pt>
          <cx:pt idx="4">90.5</cx:pt>
          <cx:pt idx="7">200.90000000000001</cx:pt>
          <cx:pt idx="8">174.90000000000001</cx:pt>
          <cx:pt idx="9">261.39999999999998</cx:pt>
          <cx:pt idx="10">196.19999999999999</cx:pt>
          <cx:pt idx="11">148.90000000000001</cx:pt>
          <cx:pt idx="14">165.09999999999999</cx:pt>
          <cx:pt idx="15">73.299999999999997</cx:pt>
          <cx:pt idx="16">143.30000000000001</cx:pt>
          <cx:pt idx="17">84.5</cx:pt>
          <cx:pt idx="18">4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L-21,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265DEA3E-DC2A-4358-9FAF-A1969F59BEF0}">
          <cx:tx>
            <cx:txData>
              <cx:f>Лист2!$C$53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67F9DAFE-7B57-4D8F-8D66-39B22BB7CEE9}">
          <cx:tx>
            <cx:txData>
              <cx:f>Лист2!$D$53</cx:f>
              <cx:v>MICAD</cx:v>
            </cx:txData>
          </cx:tx>
          <cx:dataId val="1"/>
          <cx:layoutPr>
            <cx:visibility meanLine="0" meanMarker="0" nonoutliers="0" outliers="1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  <cx:spPr>
    <a:solidFill>
      <a:schemeClr val="bg1"/>
    </a:solidFill>
  </cx:spPr>
</cx:chartSpace>
</file>

<file path=ppt/charts/chartEx10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488:$B$506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C$488:$C$506</cx:f>
        <cx:lvl ptCount="19" formatCode="Основной">
          <cx:pt idx="0">45.899999999999999</cx:pt>
          <cx:pt idx="1">47.700000000000003</cx:pt>
          <cx:pt idx="2">44.899999999999999</cx:pt>
          <cx:pt idx="3">39.799999999999997</cx:pt>
          <cx:pt idx="4">47</cx:pt>
          <cx:pt idx="7">56.899999999999999</cx:pt>
          <cx:pt idx="8">53.799999999999997</cx:pt>
          <cx:pt idx="9">56.399999999999999</cx:pt>
          <cx:pt idx="10">63.299999999999997</cx:pt>
          <cx:pt idx="11">64.400000000000006</cx:pt>
          <cx:pt idx="14">41.200000000000003</cx:pt>
          <cx:pt idx="15">43.100000000000001</cx:pt>
          <cx:pt idx="16">40.799999999999997</cx:pt>
          <cx:pt idx="17">35</cx:pt>
          <cx:pt idx="18">40.799999999999997</cx:pt>
        </cx:lvl>
      </cx:numDim>
    </cx:data>
    <cx:data id="1">
      <cx:strDim type="cat">
        <cx:f>Лист2!$B$488:$B$506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D$488:$D$506</cx:f>
        <cx:lvl ptCount="19" formatCode="Основной">
          <cx:pt idx="0">44.299999999999997</cx:pt>
          <cx:pt idx="1">42.5</cx:pt>
          <cx:pt idx="2">44.799999999999997</cx:pt>
          <cx:pt idx="3">48.899999999999999</cx:pt>
          <cx:pt idx="4">49.5</cx:pt>
          <cx:pt idx="7">47.100000000000001</cx:pt>
          <cx:pt idx="8">45.200000000000003</cx:pt>
          <cx:pt idx="9">47.5</cx:pt>
          <cx:pt idx="10">54.399999999999999</cx:pt>
          <cx:pt idx="11">52.299999999999997</cx:pt>
          <cx:pt idx="14">28.300000000000001</cx:pt>
          <cx:pt idx="15">36.100000000000001</cx:pt>
          <cx:pt idx="16">39.600000000000001</cx:pt>
          <cx:pt idx="17">45</cx:pt>
          <cx:pt idx="18">40.299999999999997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L-8,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874C4040-D721-4BD5-ABC4-AE2FC5233B12}">
          <cx:tx>
            <cx:txData>
              <cx:f>Лист2!$C$487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F7158517-B04F-471C-BCF0-ADA2B0C2F448}">
          <cx:tx>
            <cx:txData>
              <cx:f>Лист2!$D$487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1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309:$B$327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C$309:$C$327</cx:f>
        <cx:lvl ptCount="19" formatCode="Основной">
          <cx:pt idx="0">734.10000000000002</cx:pt>
          <cx:pt idx="1">696.60000000000002</cx:pt>
          <cx:pt idx="2">638.89999999999998</cx:pt>
          <cx:pt idx="3">674.60000000000002</cx:pt>
          <cx:pt idx="4">763.39999999999998</cx:pt>
          <cx:pt idx="7">876.39999999999998</cx:pt>
          <cx:pt idx="8">744.10000000000002</cx:pt>
          <cx:pt idx="9">704.10000000000002</cx:pt>
          <cx:pt idx="10">714.5</cx:pt>
          <cx:pt idx="11">904.89999999999998</cx:pt>
          <cx:pt idx="14">700.03999999999996</cx:pt>
          <cx:pt idx="15">617.76999999999998</cx:pt>
          <cx:pt idx="16">569.92999999999995</cx:pt>
          <cx:pt idx="17">578.19000000000005</cx:pt>
          <cx:pt idx="18">668.08000000000004</cx:pt>
        </cx:lvl>
      </cx:numDim>
    </cx:data>
    <cx:data id="1">
      <cx:strDim type="cat">
        <cx:f>Лист2!$B$309:$B$327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D$309:$D$327</cx:f>
        <cx:lvl ptCount="19" formatCode="Основной">
          <cx:pt idx="0">612.09000000000003</cx:pt>
          <cx:pt idx="1">606.66999999999996</cx:pt>
          <cx:pt idx="2">593.60000000000002</cx:pt>
          <cx:pt idx="3">623.20000000000005</cx:pt>
          <cx:pt idx="4">600.47000000000003</cx:pt>
          <cx:pt idx="7">739.70000000000005</cx:pt>
          <cx:pt idx="8">701.79999999999995</cx:pt>
          <cx:pt idx="9">653.10000000000002</cx:pt>
          <cx:pt idx="10">686.89999999999998</cx:pt>
          <cx:pt idx="11">743</cx:pt>
          <cx:pt idx="14">536.57000000000005</cx:pt>
          <cx:pt idx="15">543.67999999999995</cx:pt>
          <cx:pt idx="16">503.20999999999998</cx:pt>
          <cx:pt idx="17">446.57999999999998</cx:pt>
          <cx:pt idx="18">536.99000000000001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VCAM-1,  pg/ml 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4E9E34C7-F311-497F-A300-8588BBF3293B}">
          <cx:tx>
            <cx:txData>
              <cx:f>Лист2!$C$308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E0A2E526-78CC-48BD-B250-A293A10346EE}">
          <cx:tx>
            <cx:txData>
              <cx:f>Лист2!$D$308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1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373:$B$38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C$373:$C$380</cx:f>
        <cx:lvl ptCount="8" formatCode="Основной">
          <cx:pt idx="0">76.599999999999994</cx:pt>
          <cx:pt idx="1">41.899999999999999</cx:pt>
          <cx:pt idx="3">126.3</cx:pt>
          <cx:pt idx="4">124.59999999999999</cx:pt>
          <cx:pt idx="6">30.100000000000001</cx:pt>
          <cx:pt idx="7">-41.200000000000003</cx:pt>
        </cx:lvl>
      </cx:numDim>
    </cx:data>
    <cx:data id="1">
      <cx:strDim type="cat">
        <cx:f>Лист2!$B$373:$B$38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D$373:$D$380</cx:f>
        <cx:lvl ptCount="8" formatCode="Основной">
          <cx:pt idx="0">-91.75</cx:pt>
          <cx:pt idx="1">-6.9500000000000002</cx:pt>
          <cx:pt idx="3">-56.100000000000001</cx:pt>
          <cx:pt idx="4">-45.200000000000003</cx:pt>
          <cx:pt idx="6">-145.40000000000001</cx:pt>
          <cx:pt idx="7">-69.299999999999997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L-21,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FA966A69-64FD-4CE2-B5C5-D2E9024AB6BE}">
          <cx:tx>
            <cx:txData>
              <cx:f>Лист2!$C$37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4C1AC277-FB11-4131-86D7-4AFCE52C4B10}">
          <cx:tx>
            <cx:txData>
              <cx:f>Лист2!$D$37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  <cx:spPr>
    <a:solidFill>
      <a:schemeClr val="bg1"/>
    </a:solidFill>
  </cx:spPr>
  <cx:clrMapOvr bg1="lt1" tx1="dk1" bg2="lt2" tx2="dk2" accent1="accent1" accent2="accent2" accent3="accent3" accent4="accent4" accent5="accent5" accent6="accent6" hlink="hlink" folHlink="folHlink"/>
</cx:chartSpace>
</file>

<file path=ppt/charts/chartEx1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473:$B$48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C$473:$C$480</cx:f>
        <cx:lvl ptCount="8" formatCode="Основной">
          <cx:pt idx="0">3.7200000000000002</cx:pt>
          <cx:pt idx="1">-0.92000000000000004</cx:pt>
          <cx:pt idx="3">7.6500000000000004</cx:pt>
          <cx:pt idx="4">14.699999999999999</cx:pt>
          <cx:pt idx="6">0.60999999999999999</cx:pt>
          <cx:pt idx="7">-16.399999999999999</cx:pt>
        </cx:lvl>
      </cx:numDim>
    </cx:data>
    <cx:data id="1">
      <cx:strDim type="cat">
        <cx:f>Лист2!$B$473:$B$48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D$473:$D$480</cx:f>
        <cx:lvl ptCount="8" formatCode="Основной">
          <cx:pt idx="0">3.4399999999999999</cx:pt>
          <cx:pt idx="1">13.56</cx:pt>
          <cx:pt idx="3">13.6</cx:pt>
          <cx:pt idx="4">42.5</cx:pt>
          <cx:pt idx="6">-10.5</cx:pt>
          <cx:pt idx="7">2.2799999999999998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L-8,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AB0B59A6-B13D-49D1-97C6-0301092DB2B5}">
          <cx:tx>
            <cx:txData>
              <cx:f>Лист2!$C$47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0D834D0E-98C1-440F-A50E-DBDD34328BD5}">
          <cx:tx>
            <cx:txData>
              <cx:f>Лист2!$D$47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  <cx:spPr>
    <a:solidFill>
      <a:schemeClr val="bg1"/>
    </a:solidFill>
  </cx:spPr>
  <cx:clrMapOvr bg1="lt1" tx1="dk1" bg2="lt2" tx2="dk2" accent1="accent1" accent2="accent2" accent3="accent3" accent4="accent4" accent5="accent5" accent6="accent6" hlink="hlink" folHlink="folHlink"/>
</cx:chartSpace>
</file>

<file path=ppt/charts/chartEx1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343:$B$35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C$343:$C$350</cx:f>
        <cx:lvl ptCount="8" formatCode="Основной">
          <cx:pt idx="0">-21.02</cx:pt>
          <cx:pt idx="1">4.7300000000000004</cx:pt>
          <cx:pt idx="3">15.699999999999999</cx:pt>
          <cx:pt idx="4">45.200000000000003</cx:pt>
          <cx:pt idx="6">-70.900000000000006</cx:pt>
          <cx:pt idx="7">-60</cx:pt>
        </cx:lvl>
      </cx:numDim>
    </cx:data>
    <cx:data id="1">
      <cx:strDim type="cat">
        <cx:f>Лист2!$B$343:$B$35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D$343:$D$350</cx:f>
        <cx:lvl ptCount="8" formatCode="Основной">
          <cx:pt idx="0">-10.5</cx:pt>
          <cx:pt idx="1">50.149999999999999</cx:pt>
          <cx:pt idx="3">29</cx:pt>
          <cx:pt idx="4">163</cx:pt>
          <cx:pt idx="6">-56.100000000000001</cx:pt>
          <cx:pt idx="7">-58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XCL6,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5677199F-3C4B-472D-BFFB-C430406402F1}">
          <cx:tx>
            <cx:txData>
              <cx:f>Лист2!$C$34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6407229D-DC29-4962-BB56-8FFB88355FDF}">
          <cx:tx>
            <cx:txData>
              <cx:f>Лист2!$D$34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1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443:$B$45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C$443:$C$450</cx:f>
        <cx:lvl ptCount="8" formatCode="Основной">
          <cx:pt idx="0">-133.16999999999999</cx:pt>
          <cx:pt idx="1">-154</cx:pt>
          <cx:pt idx="3">380</cx:pt>
          <cx:pt idx="4">815</cx:pt>
          <cx:pt idx="6">-1999</cx:pt>
          <cx:pt idx="7">-598</cx:pt>
        </cx:lvl>
      </cx:numDim>
    </cx:data>
    <cx:data id="1">
      <cx:strDim type="cat">
        <cx:f>Лист2!$B$443:$B$45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D$443:$D$450</cx:f>
        <cx:lvl ptCount="8" formatCode="Основной">
          <cx:pt idx="0">-118</cx:pt>
          <cx:pt idx="1">-449</cx:pt>
          <cx:pt idx="3">-18.5</cx:pt>
          <cx:pt idx="4">480</cx:pt>
          <cx:pt idx="6">-1969</cx:pt>
          <cx:pt idx="7">-1177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L-15, 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B04B962B-D16C-4FCE-A382-76C88966B5AD}">
          <cx:tx>
            <cx:txData>
              <cx:f>Лист2!$C$44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814EC57E-1998-4BF0-8C75-A74E85F01A11}">
          <cx:tx>
            <cx:txData>
              <cx:f>Лист2!$D$44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16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433:$B$44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C$433:$C$440</cx:f>
        <cx:lvl ptCount="8" formatCode="Основной">
          <cx:pt idx="0">0.45000000000000001</cx:pt>
          <cx:pt idx="1">-1.75</cx:pt>
          <cx:pt idx="3">12.9</cx:pt>
          <cx:pt idx="4">24</cx:pt>
          <cx:pt idx="6">-5.5</cx:pt>
          <cx:pt idx="7">-7</cx:pt>
        </cx:lvl>
      </cx:numDim>
    </cx:data>
    <cx:data id="1">
      <cx:strDim type="cat">
        <cx:f>Лист2!$B$433:$B$44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D$433:$D$440</cx:f>
        <cx:lvl ptCount="8" formatCode="Основной">
          <cx:pt idx="0">1</cx:pt>
          <cx:pt idx="1">3.8500000000000001</cx:pt>
          <cx:pt idx="3">10</cx:pt>
          <cx:pt idx="4">54</cx:pt>
          <cx:pt idx="6">-13.699999999999999</cx:pt>
          <cx:pt idx="7">-5.2000000000000002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-20, 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125213F1-8A7C-4C3E-A41A-090CEAE71831}">
          <cx:tx>
            <cx:txData>
              <cx:f>Лист2!$C$43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7D21F4B1-A810-4460-BAA4-DBD050AD7CD7}">
          <cx:tx>
            <cx:txData>
              <cx:f>Лист2!$D$43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17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403:$B$41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C$403:$C$410</cx:f>
        <cx:lvl ptCount="8" formatCode="Основной">
          <cx:pt idx="0">-0.28000000000000003</cx:pt>
          <cx:pt idx="1">-2.54</cx:pt>
          <cx:pt idx="3">8.2300000000000004</cx:pt>
          <cx:pt idx="4">3.23</cx:pt>
          <cx:pt idx="6">-5.2000000000000002</cx:pt>
          <cx:pt idx="7">-14.9</cx:pt>
        </cx:lvl>
      </cx:numDim>
    </cx:data>
    <cx:data id="1">
      <cx:strDim type="cat">
        <cx:f>Лист2!$B$403:$B$41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D$403:$D$410</cx:f>
        <cx:lvl ptCount="8" formatCode="Основной">
          <cx:pt idx="0">-4.2599999999999998</cx:pt>
          <cx:pt idx="1">-4.5999999999999996</cx:pt>
          <cx:pt idx="3">-5.96</cx:pt>
          <cx:pt idx="4">11.02</cx:pt>
          <cx:pt idx="6">-15</cx:pt>
          <cx:pt idx="7">-5.9000000000000004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costatin M, 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4D2D969E-CB5D-4631-B626-471745F63C70}">
          <cx:tx>
            <cx:txData>
              <cx:f>Лист2!$C$40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54D5E175-92B0-43F5-9BC1-6ED428FFEF43}">
          <cx:tx>
            <cx:txData>
              <cx:f>Лист2!$D$40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18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383:$B$39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C$383:$C$390</cx:f>
        <cx:lvl ptCount="8" formatCode="Основной">
          <cx:pt idx="0">-1.1899999999999999</cx:pt>
          <cx:pt idx="1">-1.8400000000000001</cx:pt>
          <cx:pt idx="3">0.48999999999999999</cx:pt>
          <cx:pt idx="4">3.2000000000000002</cx:pt>
          <cx:pt idx="6">-8</cx:pt>
          <cx:pt idx="7">-2.5</cx:pt>
        </cx:lvl>
      </cx:numDim>
    </cx:data>
    <cx:data id="1">
      <cx:strDim type="cat">
        <cx:f>Лист2!$B$383:$B$39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D$383:$D$390</cx:f>
        <cx:lvl ptCount="8" formatCode="Основной">
          <cx:pt idx="0">0.29999999999999999</cx:pt>
          <cx:pt idx="1">0.63</cx:pt>
          <cx:pt idx="3">4.5</cx:pt>
          <cx:pt idx="4">8.3800000000000008</cx:pt>
          <cx:pt idx="6">-1.3</cx:pt>
          <cx:pt idx="7">-0.5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GF,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A43160B4-0963-4B53-ACA1-7299D485C96A}">
          <cx:tx>
            <cx:txData>
              <cx:f>Лист2!$C$38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5985C6C3-2314-4EEC-8A51-B9A0DD127F19}">
          <cx:tx>
            <cx:txData>
              <cx:f>Лист2!$D$38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19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413:$B$42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C$413:$C$420</cx:f>
        <cx:lvl ptCount="8" formatCode="Основной">
          <cx:pt idx="0">10.609999999999999</cx:pt>
          <cx:pt idx="1">7.0199999999999996</cx:pt>
          <cx:pt idx="3">12.4</cx:pt>
          <cx:pt idx="4">26.969999999999999</cx:pt>
          <cx:pt idx="6">-1.1000000000000001</cx:pt>
          <cx:pt idx="7">-4</cx:pt>
        </cx:lvl>
      </cx:numDim>
    </cx:data>
    <cx:data id="1">
      <cx:strDim type="cat">
        <cx:f>Лист2!$B$413:$B$42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D$413:$D$420</cx:f>
        <cx:lvl ptCount="8" formatCode="Основной">
          <cx:pt idx="0">-7.8700000000000001</cx:pt>
          <cx:pt idx="1">7.3099999999999996</cx:pt>
          <cx:pt idx="3">8.8800000000000008</cx:pt>
          <cx:pt idx="4">25</cx:pt>
          <cx:pt idx="6">-52</cx:pt>
          <cx:pt idx="7">-8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-Selectin, 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BDA24F4A-D16E-468D-BD14-1E6BF1A5FED9}">
          <cx:tx>
            <cx:txData>
              <cx:f>Лист2!$C$41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ECD044E1-C348-46C2-8477-826C199F83C1}">
          <cx:tx>
            <cx:txData>
              <cx:f>Лист2!$D$41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75:$B$93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C$75:$C$93</cx:f>
        <cx:lvl ptCount="19" formatCode="Основной">
          <cx:pt idx="0">10.960000000000001</cx:pt>
          <cx:pt idx="1">11.869999999999999</cx:pt>
          <cx:pt idx="2">8.0700000000000003</cx:pt>
          <cx:pt idx="3">7.9100000000000001</cx:pt>
          <cx:pt idx="4">7.7300000000000004</cx:pt>
          <cx:pt idx="7">23.390000000000001</cx:pt>
          <cx:pt idx="8">16.719999999999999</cx:pt>
          <cx:pt idx="9">16.859999999999999</cx:pt>
          <cx:pt idx="10">14.74</cx:pt>
          <cx:pt idx="11">12.27</cx:pt>
          <cx:pt idx="14">5.4100000000000001</cx:pt>
          <cx:pt idx="15">5.3399999999999999</cx:pt>
          <cx:pt idx="16">3.1099999999999999</cx:pt>
          <cx:pt idx="17">5.2000000000000002</cx:pt>
          <cx:pt idx="18">4.0800000000000001</cx:pt>
        </cx:lvl>
      </cx:numDim>
    </cx:data>
    <cx:data id="1">
      <cx:strDim type="cat">
        <cx:f>Лист2!$B$75:$B$93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D$75:$D$93</cx:f>
        <cx:lvl ptCount="19" formatCode="Основной">
          <cx:pt idx="0">4.54</cx:pt>
          <cx:pt idx="1">3.1499999999999999</cx:pt>
          <cx:pt idx="2">2.79</cx:pt>
          <cx:pt idx="3">2.5600000000000001</cx:pt>
          <cx:pt idx="4">2.6899999999999999</cx:pt>
          <cx:pt idx="7">7.6699999999999999</cx:pt>
          <cx:pt idx="8">8.7300000000000004</cx:pt>
          <cx:pt idx="9">11.359999999999999</cx:pt>
          <cx:pt idx="10">3.9500000000000002</cx:pt>
          <cx:pt idx="11">9.0099999999999998</cx:pt>
          <cx:pt idx="14">0.34000000000000002</cx:pt>
          <cx:pt idx="15">0.32000000000000001</cx:pt>
          <cx:pt idx="16">0.83999999999999997</cx:pt>
          <cx:pt idx="17">0.27000000000000002</cx:pt>
          <cx:pt idx="18">1.3500000000000001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GF,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DBC69A13-1878-40D7-8D4E-324108274B67}">
          <cx:tx>
            <cx:txData>
              <cx:f>Лист2!$C$74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80DE1EB5-F236-456A-8B27-67BC525B99B9}">
          <cx:tx>
            <cx:txData>
              <cx:f>Лист2!$D$74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  <cx:spPr>
    <a:solidFill>
      <a:schemeClr val="bg1"/>
    </a:solidFill>
  </cx:spPr>
</cx:chartSpace>
</file>

<file path=ppt/charts/chartEx20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393:$B$40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C$393:$C$400</cx:f>
        <cx:lvl ptCount="8" formatCode="Основной">
          <cx:pt idx="0">42.490000000000002</cx:pt>
          <cx:pt idx="1">-73</cx:pt>
          <cx:pt idx="3">178</cx:pt>
          <cx:pt idx="4">10.75</cx:pt>
          <cx:pt idx="6">-90</cx:pt>
          <cx:pt idx="7">-100</cx:pt>
        </cx:lvl>
      </cx:numDim>
    </cx:data>
    <cx:data id="1">
      <cx:strDim type="cat">
        <cx:f>Лист2!$B$393:$B$40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D$393:$D$400</cx:f>
        <cx:lvl ptCount="8" formatCode="Основной">
          <cx:pt idx="0">-82.920000000000002</cx:pt>
          <cx:pt idx="1">25.379999999999999</cx:pt>
          <cx:pt idx="3">-15</cx:pt>
          <cx:pt idx="4">105</cx:pt>
          <cx:pt idx="6">-300</cx:pt>
          <cx:pt idx="7">-89.900000000000006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GHT, 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56AA560E-5125-4FB8-968E-0490991E2759}">
          <cx:tx>
            <cx:txData>
              <cx:f>Лист2!$C$39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712778AE-DF33-4002-9286-EB2F0AA3935F}">
          <cx:tx>
            <cx:txData>
              <cx:f>Лист2!$D$39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2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453:$B$46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C$453:$C$460</cx:f>
        <cx:lvl ptCount="8" formatCode="Основной">
          <cx:pt idx="0">-1463.46</cx:pt>
          <cx:pt idx="1">-246.5</cx:pt>
          <cx:pt idx="3">-723</cx:pt>
          <cx:pt idx="4">-23</cx:pt>
          <cx:pt idx="6">-2423</cx:pt>
          <cx:pt idx="7">-600</cx:pt>
        </cx:lvl>
      </cx:numDim>
    </cx:data>
    <cx:data id="1">
      <cx:strDim type="cat">
        <cx:f>Лист2!$B$453:$B$46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D$453:$D$460</cx:f>
        <cx:lvl ptCount="8" formatCode="Основной">
          <cx:pt idx="0">-614</cx:pt>
          <cx:pt idx="1">-2.5</cx:pt>
          <cx:pt idx="3">-278.05000000000001</cx:pt>
          <cx:pt idx="4">830</cx:pt>
          <cx:pt idx="6">-1500</cx:pt>
          <cx:pt idx="7">-210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docan-1, 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A7AC9B39-3365-414F-8500-05FF701D7749}">
          <cx:tx>
            <cx:txData>
              <cx:f>Лист2!$C$45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BA76B496-E86C-4618-A225-8390E38D77A1}">
          <cx:tx>
            <cx:txData>
              <cx:f>Лист2!$D$45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1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2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463:$B$47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C$463:$C$470</cx:f>
        <cx:lvl ptCount="8" formatCode="Основной">
          <cx:pt idx="0">34</cx:pt>
          <cx:pt idx="1">131</cx:pt>
          <cx:pt idx="3">95</cx:pt>
          <cx:pt idx="4">213</cx:pt>
          <cx:pt idx="6">-12</cx:pt>
          <cx:pt idx="7">-31</cx:pt>
        </cx:lvl>
      </cx:numDim>
    </cx:data>
    <cx:data id="1">
      <cx:strDim type="cat">
        <cx:f>Лист2!$B$463:$B$470</cx:f>
        <cx:lvl ptCount="8">
          <cx:pt idx="0">Δ1</cx:pt>
          <cx:pt idx="1">Δ2</cx:pt>
          <cx:pt idx="3">Δ1</cx:pt>
          <cx:pt idx="4">Δ2</cx:pt>
          <cx:pt idx="6">Δ1</cx:pt>
          <cx:pt idx="7">Δ2</cx:pt>
        </cx:lvl>
      </cx:strDim>
      <cx:numDim type="val">
        <cx:f>Лист2!$D$463:$D$470</cx:f>
        <cx:lvl ptCount="8" formatCode="Основной">
          <cx:pt idx="0">-15.960000000000001</cx:pt>
          <cx:pt idx="1">-16.5</cx:pt>
          <cx:pt idx="3">53</cx:pt>
          <cx:pt idx="4">156</cx:pt>
          <cx:pt idx="6">-65</cx:pt>
          <cx:pt idx="7">-44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VCAM-1,  pg/ml 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E65F9B78-7A82-4F20-A82A-6BCC7A0F8B2F}">
          <cx:tx>
            <cx:txData>
              <cx:f>Лист2!$C$46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C48F4E73-AF9B-453C-AD41-4C5DEFDB733C}">
          <cx:tx>
            <cx:txData>
              <cx:f>Лист2!$D$46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Calibri" panose="020F0502020204030204"/>
              </a:defRPr>
            </a:pPr>
            <a:endParaRPr lang="ru-RU" sz="1000">
              <a:solidFill>
                <a:schemeClr val="tx1"/>
              </a:solidFill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97:$B$115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C$97:$C$115</cx:f>
        <cx:lvl ptCount="19" formatCode="Основной">
          <cx:pt idx="0">195.75999999999999</cx:pt>
          <cx:pt idx="1">190.69999999999999</cx:pt>
          <cx:pt idx="2">199.44999999999999</cx:pt>
          <cx:pt idx="3">247.05000000000001</cx:pt>
          <cx:pt idx="4">226.16999999999999</cx:pt>
          <cx:pt idx="7">245.30000000000001</cx:pt>
          <cx:pt idx="8">310.35000000000002</cx:pt>
          <cx:pt idx="9">305.81999999999999</cx:pt>
          <cx:pt idx="10">388.44</cx:pt>
          <cx:pt idx="11">392.93000000000001</cx:pt>
          <cx:pt idx="14">114.81999999999999</cx:pt>
          <cx:pt idx="15">167.49000000000001</cx:pt>
          <cx:pt idx="16">146.94</cx:pt>
          <cx:pt idx="17">182.33000000000001</cx:pt>
          <cx:pt idx="18">114.03</cx:pt>
        </cx:lvl>
      </cx:numDim>
    </cx:data>
    <cx:data id="1">
      <cx:strDim type="cat">
        <cx:f>Лист2!$B$97:$B$115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D$97:$D$115</cx:f>
        <cx:lvl ptCount="19" formatCode="Основной">
          <cx:pt idx="0">250</cx:pt>
          <cx:pt idx="1">230</cx:pt>
          <cx:pt idx="2">212.28999999999999</cx:pt>
          <cx:pt idx="3">263.52999999999997</cx:pt>
          <cx:pt idx="4">193.02000000000001</cx:pt>
          <cx:pt idx="7">350</cx:pt>
          <cx:pt idx="8">380</cx:pt>
          <cx:pt idx="9">311.64999999999998</cx:pt>
          <cx:pt idx="10">322.50999999999999</cx:pt>
          <cx:pt idx="11">284.08999999999997</cx:pt>
          <cx:pt idx="14">194.88999999999999</cx:pt>
          <cx:pt idx="15">197.02000000000001</cx:pt>
          <cx:pt idx="16">110.12</cx:pt>
          <cx:pt idx="17">177.80000000000001</cx:pt>
          <cx:pt idx="18">83.019999999999996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sz="1200"/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GHT,  pg/ml</a:t>
            </a:r>
            <a:endParaRPr lang="ru-RU" sz="14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F446D1A1-4F86-47BC-914D-F7777B575C6C}">
          <cx:tx>
            <cx:txData>
              <cx:f>Лист2!$C$96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167C5F06-364F-49F2-91A3-D07E2A5370E8}">
          <cx:tx>
            <cx:txData>
              <cx:f>Лист2!$D$96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182:$B$200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C$182:$C$200</cx:f>
        <cx:lvl ptCount="19" formatCode="Основной">
          <cx:pt idx="0">26.899999999999999</cx:pt>
          <cx:pt idx="1">25.82</cx:pt>
          <cx:pt idx="2">29.629999999999999</cx:pt>
          <cx:pt idx="3">38.619999999999997</cx:pt>
          <cx:pt idx="4">26.739999999999998</cx:pt>
          <cx:pt idx="7">34.920000000000002</cx:pt>
          <cx:pt idx="8">34.490000000000002</cx:pt>
          <cx:pt idx="9">38.560000000000002</cx:pt>
          <cx:pt idx="10">53.200000000000003</cx:pt>
          <cx:pt idx="11">38.259999999999998</cx:pt>
          <cx:pt idx="14">7.4400000000000004</cx:pt>
          <cx:pt idx="15">7.4400000000000004</cx:pt>
          <cx:pt idx="16">9.4100000000000001</cx:pt>
          <cx:pt idx="17">17.449999999999999</cx:pt>
          <cx:pt idx="18">17.710000000000001</cx:pt>
        </cx:lvl>
      </cx:numDim>
    </cx:data>
    <cx:data id="1">
      <cx:strDim type="cat">
        <cx:f>Лист2!$B$182:$B$200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D$182:$D$200</cx:f>
        <cx:lvl ptCount="19" formatCode="Основной">
          <cx:pt idx="0">21.48</cx:pt>
          <cx:pt idx="1">13.32</cx:pt>
          <cx:pt idx="2">16.559999999999999</cx:pt>
          <cx:pt idx="3">14.33</cx:pt>
          <cx:pt idx="4">12.33</cx:pt>
          <cx:pt idx="7">25.359999999999999</cx:pt>
          <cx:pt idx="8">25.02</cx:pt>
          <cx:pt idx="9">23.829999999999998</cx:pt>
          <cx:pt idx="10">23.690000000000001</cx:pt>
          <cx:pt idx="11">20.899999999999999</cx:pt>
          <cx:pt idx="14">14.83</cx:pt>
          <cx:pt idx="15">9.1199999999999992</cx:pt>
          <cx:pt idx="16">6.3200000000000003</cx:pt>
          <cx:pt idx="17">6.9100000000000001</cx:pt>
          <cx:pt idx="18">7.2400000000000002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/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costatin M,  pg/ml</a:t>
            </a:r>
            <a:endParaRPr lang="ru-RU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514DB9BE-511D-4BAA-898D-0CA223C6C632}">
          <cx:tx>
            <cx:txData>
              <cx:f>Лист2!$C$181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3955B8ED-E5E7-4B23-BBDB-C903C8F8D9EB}">
          <cx:tx>
            <cx:txData>
              <cx:f>Лист2!$D$181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203:$B$221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C$203:$C$221</cx:f>
        <cx:lvl ptCount="19" formatCode="Основной">
          <cx:pt idx="0">69.450000000000003</cx:pt>
          <cx:pt idx="1">67.150000000000006</cx:pt>
          <cx:pt idx="2">68.870000000000005</cx:pt>
          <cx:pt idx="3">73.480000000000004</cx:pt>
          <cx:pt idx="4">82.629999999999995</cx:pt>
          <cx:pt idx="7">79.810000000000002</cx:pt>
          <cx:pt idx="8">85.239999999999995</cx:pt>
          <cx:pt idx="9">83.769999999999996</cx:pt>
          <cx:pt idx="10">79.810000000000002</cx:pt>
          <cx:pt idx="11">92.930000000000007</cx:pt>
          <cx:pt idx="14">64.950000000000003</cx:pt>
          <cx:pt idx="15">61.149999999999999</cx:pt>
          <cx:pt idx="16">44.310000000000002</cx:pt>
          <cx:pt idx="17">49.979999999999997</cx:pt>
          <cx:pt idx="18">54.310000000000002</cx:pt>
        </cx:lvl>
      </cx:numDim>
    </cx:data>
    <cx:data id="1">
      <cx:strDim type="cat">
        <cx:f>Лист2!$B$203:$B$221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D$203:$D$221</cx:f>
        <cx:lvl ptCount="19" formatCode="Основной">
          <cx:pt idx="0">78.040000000000006</cx:pt>
          <cx:pt idx="1">86.790000000000006</cx:pt>
          <cx:pt idx="2">67.079999999999998</cx:pt>
          <cx:pt idx="3">66.739999999999995</cx:pt>
          <cx:pt idx="4">67.75</cx:pt>
          <cx:pt idx="7">117.54000000000001</cx:pt>
          <cx:pt idx="8">120.79000000000001</cx:pt>
          <cx:pt idx="9">88.329999999999998</cx:pt>
          <cx:pt idx="10">87.430000000000007</cx:pt>
          <cx:pt idx="11">94.659999999999997</cx:pt>
          <cx:pt idx="14">47.25</cx:pt>
          <cx:pt idx="15">60.409999999999997</cx:pt>
          <cx:pt idx="16">44.810000000000002</cx:pt>
          <cx:pt idx="17">45.32</cx:pt>
          <cx:pt idx="18">55.710000000000001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-Selectin, 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124C883D-FBB3-401A-9A35-4DCFEE5B02D6}">
          <cx:tx>
            <cx:txData>
              <cx:f>Лист2!$C$202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32E6A416-5FBF-4311-A98D-4FA0DC7AAC4B}">
          <cx:tx>
            <cx:txData>
              <cx:f>Лист2!$D$202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  <cx:spPr>
    <a:solidFill>
      <a:schemeClr val="bg1"/>
    </a:solidFill>
  </cx:spPr>
</cx:chartSpace>
</file>

<file path=ppt/charts/chartEx6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245:$B$263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C$245:$C$263</cx:f>
        <cx:lvl ptCount="19" formatCode="Основной">
          <cx:pt idx="0">59.200000000000003</cx:pt>
          <cx:pt idx="1">63.5</cx:pt>
          <cx:pt idx="2">54.299999999999997</cx:pt>
          <cx:pt idx="3">57.899999999999999</cx:pt>
          <cx:pt idx="4">58.200000000000003</cx:pt>
          <cx:pt idx="7">84.099999999999994</cx:pt>
          <cx:pt idx="8">90.200000000000003</cx:pt>
          <cx:pt idx="9">70.5</cx:pt>
          <cx:pt idx="10">73.299999999999997</cx:pt>
          <cx:pt idx="11">76.599999999999994</cx:pt>
          <cx:pt idx="14">46.799999999999997</cx:pt>
          <cx:pt idx="15">50.5</cx:pt>
          <cx:pt idx="16">45</cx:pt>
          <cx:pt idx="17">45.700000000000003</cx:pt>
          <cx:pt idx="18">43.700000000000003</cx:pt>
        </cx:lvl>
      </cx:numDim>
    </cx:data>
    <cx:data id="1">
      <cx:strDim type="cat">
        <cx:f>Лист2!$B$245:$B$263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D$245:$D$263</cx:f>
        <cx:lvl ptCount="19" formatCode="Основной">
          <cx:pt idx="0">48.899999999999999</cx:pt>
          <cx:pt idx="1">40</cx:pt>
          <cx:pt idx="2">43.5</cx:pt>
          <cx:pt idx="3">55.299999999999997</cx:pt>
          <cx:pt idx="4">56.899999999999999</cx:pt>
          <cx:pt idx="7">60.799999999999997</cx:pt>
          <cx:pt idx="8">48.899999999999999</cx:pt>
          <cx:pt idx="9">51.100000000000001</cx:pt>
          <cx:pt idx="10">58.799999999999997</cx:pt>
          <cx:pt idx="11">69.599999999999994</cx:pt>
          <cx:pt idx="14">48.100000000000001</cx:pt>
          <cx:pt idx="15">28.800000000000001</cx:pt>
          <cx:pt idx="16">41.700000000000003</cx:pt>
          <cx:pt idx="17">38.899999999999999</cx:pt>
          <cx:pt idx="18">42.600000000000001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-20, 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B19CBA0D-3C79-472D-9F06-2425875C5074}">
          <cx:tx>
            <cx:txData>
              <cx:f>Лист2!$C$244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DDF78EBD-A9F7-4C47-AA2A-6A637709CDBC}">
          <cx:tx>
            <cx:txData>
              <cx:f>Лист2!$D$244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  <cx:spPr>
    <a:solidFill>
      <a:schemeClr val="bg1"/>
    </a:solidFill>
  </cx:spPr>
</cx:chartSpace>
</file>

<file path=ppt/charts/chartEx7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267:$B$285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C$267:$C$285</cx:f>
        <cx:lvl ptCount="19" formatCode="Основной">
          <cx:pt idx="0">4931</cx:pt>
          <cx:pt idx="1">5683.5</cx:pt>
          <cx:pt idx="2">5261</cx:pt>
          <cx:pt idx="3">4906.5</cx:pt>
          <cx:pt idx="4">3694</cx:pt>
          <cx:pt idx="7">7496.5</cx:pt>
          <cx:pt idx="8">7168</cx:pt>
          <cx:pt idx="9">6171</cx:pt>
          <cx:pt idx="10">5733.5</cx:pt>
          <cx:pt idx="11">5428</cx:pt>
          <cx:pt idx="14">3317.5</cx:pt>
          <cx:pt idx="15">3284</cx:pt>
          <cx:pt idx="16">3355</cx:pt>
          <cx:pt idx="17">4199.5</cx:pt>
          <cx:pt idx="18">2623.5</cx:pt>
        </cx:lvl>
      </cx:numDim>
    </cx:data>
    <cx:data id="1">
      <cx:strDim type="cat">
        <cx:f>Лист2!$B$267:$B$285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D$267:$D$285</cx:f>
        <cx:lvl ptCount="19" formatCode="Основной">
          <cx:pt idx="0">3022.5</cx:pt>
          <cx:pt idx="1">3500</cx:pt>
          <cx:pt idx="2">2606</cx:pt>
          <cx:pt idx="3">3732</cx:pt>
          <cx:pt idx="4">2657</cx:pt>
          <cx:pt idx="7">4574</cx:pt>
          <cx:pt idx="8">4098</cx:pt>
          <cx:pt idx="9">3851</cx:pt>
          <cx:pt idx="10">3951</cx:pt>
          <cx:pt idx="11">3319</cx:pt>
          <cx:pt idx="14">2006</cx:pt>
          <cx:pt idx="15">2901</cx:pt>
          <cx:pt idx="16">2389</cx:pt>
          <cx:pt idx="17">2653</cx:pt>
          <cx:pt idx="18">2154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L-15, 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5106F5E3-D656-4A9A-B51A-70A651DB98F9}">
          <cx:tx>
            <cx:txData>
              <cx:f>Лист2!$C$266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5D71E7C5-B501-4313-BA37-CB8ED630F729}">
          <cx:tx>
            <cx:txData>
              <cx:f>Лист2!$D$266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hartEx8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288:$B$306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C$288:$C$306</cx:f>
        <cx:lvl ptCount="19" formatCode="Основной">
          <cx:pt idx="0">2467.5</cx:pt>
          <cx:pt idx="1">1650.5</cx:pt>
          <cx:pt idx="2">1240.5</cx:pt>
          <cx:pt idx="3">1287</cx:pt>
          <cx:pt idx="4">999.45000000000005</cx:pt>
          <cx:pt idx="7">3489</cx:pt>
          <cx:pt idx="8">3744</cx:pt>
          <cx:pt idx="9">1895</cx:pt>
          <cx:pt idx="10">1935</cx:pt>
          <cx:pt idx="11">1171</cx:pt>
          <cx:pt idx="14">1542</cx:pt>
          <cx:pt idx="15">1551</cx:pt>
          <cx:pt idx="16">858.11000000000001</cx:pt>
          <cx:pt idx="17">856.63999999999999</cx:pt>
          <cx:pt idx="18">786.86000000000001</cx:pt>
        </cx:lvl>
      </cx:numDim>
    </cx:data>
    <cx:data id="1">
      <cx:strDim type="cat">
        <cx:f>Лист2!$B$288:$B$306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D$288:$D$306</cx:f>
        <cx:lvl ptCount="19" formatCode="Основной">
          <cx:pt idx="0">1861</cx:pt>
          <cx:pt idx="1">1469.5</cx:pt>
          <cx:pt idx="2">1608</cx:pt>
          <cx:pt idx="3">1241</cx:pt>
          <cx:pt idx="4">1005.49</cx:pt>
          <cx:pt idx="7">2630.5</cx:pt>
          <cx:pt idx="8">3319.5</cx:pt>
          <cx:pt idx="9">2190</cx:pt>
          <cx:pt idx="10">1467.5</cx:pt>
          <cx:pt idx="11">1410</cx:pt>
          <cx:pt idx="14">1369.5</cx:pt>
          <cx:pt idx="15">1165</cx:pt>
          <cx:pt idx="16">1040.29</cx:pt>
          <cx:pt idx="17">1042.5</cx:pt>
          <cx:pt idx="18">861.90999999999997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 lang="ru-RU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docan-1,  pg/ml</a:t>
            </a:r>
            <a:endParaRPr lang="ru-RU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BD7EBDD0-AC72-4997-9E1F-54700E23BCA9}">
          <cx:tx>
            <cx:txData>
              <cx:f>Лист2!$C$287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9004208D-DBA2-4032-9793-D9CD042C595D}">
          <cx:tx>
            <cx:txData>
              <cx:f>Лист2!$D$287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  <cx:spPr>
    <a:solidFill>
      <a:schemeClr val="bg1"/>
    </a:solidFill>
  </cx:spPr>
</cx:chartSpace>
</file>

<file path=ppt/charts/chartEx9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Лист2!$B$140:$B$158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C$140:$C$158</cx:f>
        <cx:lvl ptCount="19" formatCode="Основной">
          <cx:pt idx="0">247.33000000000001</cx:pt>
          <cx:pt idx="1">218.81</cx:pt>
          <cx:pt idx="2">236.81</cx:pt>
          <cx:pt idx="3">242.97</cx:pt>
          <cx:pt idx="4">227.28</cx:pt>
          <cx:pt idx="7">281.88999999999999</cx:pt>
          <cx:pt idx="8">229</cx:pt>
          <cx:pt idx="9">252.11000000000001</cx:pt>
          <cx:pt idx="10">288.76999999999998</cx:pt>
          <cx:pt idx="11">271.69999999999999</cx:pt>
          <cx:pt idx="14">213.34</cx:pt>
          <cx:pt idx="15">201.16999999999999</cx:pt>
          <cx:pt idx="16">219.44</cx:pt>
          <cx:pt idx="17">226.40000000000001</cx:pt>
          <cx:pt idx="18">208.75</cx:pt>
        </cx:lvl>
      </cx:numDim>
    </cx:data>
    <cx:data id="1">
      <cx:strDim type="cat">
        <cx:f>Лист2!$B$140:$B$158</cx:f>
        <cx:lvl ptCount="19">
          <cx:pt idx="0">1  day</cx:pt>
          <cx:pt idx="1">2 day</cx:pt>
          <cx:pt idx="2">4 day</cx:pt>
          <cx:pt idx="3">7 day</cx:pt>
          <cx:pt idx="4">1 year</cx:pt>
          <cx:pt idx="7">1  day</cx:pt>
          <cx:pt idx="8">2 day</cx:pt>
          <cx:pt idx="9">4 day</cx:pt>
          <cx:pt idx="10">7 day</cx:pt>
          <cx:pt idx="11">1 year</cx:pt>
          <cx:pt idx="14">1  day</cx:pt>
          <cx:pt idx="15">2 day</cx:pt>
          <cx:pt idx="16">4 day</cx:pt>
          <cx:pt idx="17">7 day</cx:pt>
          <cx:pt idx="18">1 year</cx:pt>
        </cx:lvl>
      </cx:strDim>
      <cx:numDim type="val">
        <cx:f>Лист2!$D$140:$D$158</cx:f>
        <cx:lvl ptCount="19" formatCode="Основной">
          <cx:pt idx="0">224.05000000000001</cx:pt>
          <cx:pt idx="1">244.34999999999999</cx:pt>
          <cx:pt idx="2">218.88</cx:pt>
          <cx:pt idx="3">229.03</cx:pt>
          <cx:pt idx="4">270</cx:pt>
          <cx:pt idx="7">315.44999999999999</cx:pt>
          <cx:pt idx="8">289.62</cx:pt>
          <cx:pt idx="9">246.74000000000001</cx:pt>
          <cx:pt idx="10">275.94</cx:pt>
          <cx:pt idx="11">301.63999999999999</cx:pt>
          <cx:pt idx="14">167.99000000000001</cx:pt>
          <cx:pt idx="15">201.31</cx:pt>
          <cx:pt idx="16">175.84</cx:pt>
          <cx:pt idx="17">214.06999999999999</cx:pt>
          <cx:pt idx="18">180</cx:pt>
        </cx:lvl>
      </cx:numDim>
    </cx:data>
  </cx:chartData>
  <cx:chart>
    <cx:title pos="t" align="ctr" overlay="0">
      <cx:tx>
        <cx:rich>
          <a:bodyPr rot="0" spcFirstLastPara="1" vertOverflow="ellipsis" vert="horz" wrap="square" lIns="0" tIns="0" rIns="0" bIns="0" anchor="ctr" anchorCtr="1"/>
          <a:lstStyle/>
          <a:p>
            <a:pPr algn="ctr">
              <a:defRPr/>
            </a:pPr>
            <a:r>
              <a:rPr lang="en-US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XCL6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ru-RU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ml</a:t>
            </a:r>
            <a:endParaRPr lang="ru-RU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rich>
      </cx:tx>
    </cx:title>
    <cx:plotArea>
      <cx:plotAreaRegion>
        <cx:series layoutId="boxWhisker" uniqueId="{D3E6C4E0-2063-40BE-B806-2291BA1DA368}">
          <cx:tx>
            <cx:txData>
              <cx:f>Лист2!$C$139</cx:f>
              <cx:v>MINOCA</cx:v>
            </cx:txData>
          </cx:tx>
          <cx:dataId val="0"/>
          <cx:layoutPr>
            <cx:visibility meanLine="0" meanMarker="0" nonoutliers="0" outliers="0"/>
            <cx:statistics quartileMethod="inclusive"/>
          </cx:layoutPr>
        </cx:series>
        <cx:series layoutId="boxWhisker" uniqueId="{06A1D18F-886B-4943-9182-38A7229DF7D7}">
          <cx:tx>
            <cx:txData>
              <cx:f>Лист2!$D$139</cx:f>
              <cx:v>MICAD</cx:v>
            </cx:txData>
          </cx:tx>
          <cx:dataId val="1"/>
          <cx:layoutPr>
            <cx:visibility meanLine="0" meanMarker="0" nonoutliers="0" outliers="0"/>
            <cx:statistics quartileMethod="inclusive"/>
          </cx:layoutPr>
        </cx:series>
      </cx:plotAreaRegion>
      <cx:axis id="0">
        <cx:catScaling gapWidth="0.949999988"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  <cx:axis id="1">
        <cx:valScaling/>
        <cx:majorGridlines/>
        <cx:tickLabels/>
        <cx:txPr>
          <a:bodyPr rot="-60000000" spcFirstLastPara="1" vertOverflow="ellipsis" vert="horz" wrap="square" lIns="0" tIns="0" rIns="0" bIns="0" anchor="ctr" anchorCtr="1"/>
          <a:lstStyle/>
          <a:p>
            <a:pPr>
              <a:defRPr lang="ru-RU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ru-RU" sz="10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x:tx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10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1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1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1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1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15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16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17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18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19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20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2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2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  <cs:bodyPr rot="-60000000" vert="horz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tx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</cs:dropLine>
  <cs:errorBar>
    <cs:lnRef idx="0"/>
    <cs:fillRef idx="0"/>
    <cs:effectRef idx="0"/>
    <cs:fontRef idx="minor">
      <a:schemeClr val="tx1"/>
    </cs:fontRef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>
        <a:solidFill>
          <a:schemeClr val="tx1">
            <a:lumMod val="15000"/>
            <a:lumOff val="85000"/>
            <a:lumOff val="10000"/>
          </a:schemeClr>
        </a:solidFill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  <cs:bodyPr rot="-60000000" vert="horz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  <cs:bodyPr rot="0" vert="horz"/>
  </cs:title>
  <cs:trendline>
    <cs:lnRef idx="0"/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  <cs:bodyPr rot="-60000000" vert="horz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B77F8C-D3A2-4C9A-BDAD-B824E266E32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108B8F-183A-4284-8743-CE0C98FF9D9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930644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E3BEC9-EBB2-422C-A3BE-0D40781731F3}" type="slidenum">
              <a:rPr lang="ru-RU" smtClean="0"/>
              <a:t>3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157435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ru-RU" smtClean="0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53901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536166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252232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471873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4295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17940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504240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17423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541000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78343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ru-RU" smtClean="0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95737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0D839F-1EB7-4DDD-978B-DC144A7FDDFB}" type="datetimeFigureOut">
              <a:rPr lang="ru-RU" smtClean="0"/>
              <a:t>20.11.2023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05F3D-2442-4396-91F1-C043919B166F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74694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14/relationships/chartEx" Target="../charts/chartEx4.xml"/><Relationship Id="rId13" Type="http://schemas.openxmlformats.org/officeDocument/2006/relationships/image" Target="../media/image6.png"/><Relationship Id="rId18" Type="http://schemas.openxmlformats.org/officeDocument/2006/relationships/image" Target="../media/image9.png"/><Relationship Id="rId3" Type="http://schemas.openxmlformats.org/officeDocument/2006/relationships/image" Target="../media/image1.png"/><Relationship Id="rId21" Type="http://schemas.microsoft.com/office/2014/relationships/chartEx" Target="../charts/chartEx10.xml"/><Relationship Id="rId7" Type="http://schemas.openxmlformats.org/officeDocument/2006/relationships/image" Target="../media/image3.png"/><Relationship Id="rId12" Type="http://schemas.microsoft.com/office/2014/relationships/chartEx" Target="../charts/chartEx6.xml"/><Relationship Id="rId17" Type="http://schemas.openxmlformats.org/officeDocument/2006/relationships/image" Target="../media/image8.png"/><Relationship Id="rId2" Type="http://schemas.microsoft.com/office/2014/relationships/chartEx" Target="../charts/chartEx1.xml"/><Relationship Id="rId16" Type="http://schemas.microsoft.com/office/2014/relationships/chartEx" Target="../charts/chartEx8.xml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microsoft.com/office/2014/relationships/chartEx" Target="../charts/chartEx3.xml"/><Relationship Id="rId11" Type="http://schemas.openxmlformats.org/officeDocument/2006/relationships/image" Target="../media/image5.png"/><Relationship Id="rId24" Type="http://schemas.openxmlformats.org/officeDocument/2006/relationships/image" Target="../media/image12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microsoft.com/office/2014/relationships/chartEx" Target="../charts/chartEx11.xml"/><Relationship Id="rId10" Type="http://schemas.microsoft.com/office/2014/relationships/chartEx" Target="../charts/chartEx5.xml"/><Relationship Id="rId19" Type="http://schemas.microsoft.com/office/2014/relationships/chartEx" Target="../charts/chartEx9.xml"/><Relationship Id="rId4" Type="http://schemas.microsoft.com/office/2014/relationships/chartEx" Target="../charts/chartEx2.xml"/><Relationship Id="rId9" Type="http://schemas.openxmlformats.org/officeDocument/2006/relationships/image" Target="../media/image4.png"/><Relationship Id="rId14" Type="http://schemas.microsoft.com/office/2014/relationships/chartEx" Target="../charts/chartEx7.xml"/><Relationship Id="rId22" Type="http://schemas.openxmlformats.org/officeDocument/2006/relationships/image" Target="../media/image1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14/relationships/chartEx" Target="../charts/chartEx14.xml"/><Relationship Id="rId13" Type="http://schemas.openxmlformats.org/officeDocument/2006/relationships/image" Target="../media/image17.png"/><Relationship Id="rId18" Type="http://schemas.microsoft.com/office/2014/relationships/chartEx" Target="../charts/chartEx19.xml"/><Relationship Id="rId3" Type="http://schemas.microsoft.com/office/2014/relationships/chartEx" Target="../charts/chartEx12.xml"/><Relationship Id="rId21" Type="http://schemas.openxmlformats.org/officeDocument/2006/relationships/image" Target="../media/image21.png"/><Relationship Id="rId7" Type="http://schemas.openxmlformats.org/officeDocument/2006/relationships/image" Target="../media/image9.png"/><Relationship Id="rId12" Type="http://schemas.microsoft.com/office/2014/relationships/chartEx" Target="../charts/chartEx16.xml"/><Relationship Id="rId17" Type="http://schemas.openxmlformats.org/officeDocument/2006/relationships/image" Target="../media/image19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microsoft.com/office/2014/relationships/chartEx" Target="../charts/chartEx18.xml"/><Relationship Id="rId20" Type="http://schemas.microsoft.com/office/2014/relationships/chartEx" Target="../charts/chartEx20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openxmlformats.org/officeDocument/2006/relationships/image" Target="../media/image16.png"/><Relationship Id="rId24" Type="http://schemas.microsoft.com/office/2014/relationships/chartEx" Target="../charts/chartEx22.xml"/><Relationship Id="rId5" Type="http://schemas.microsoft.com/office/2014/relationships/chartEx" Target="../charts/chartEx13.xml"/><Relationship Id="rId15" Type="http://schemas.openxmlformats.org/officeDocument/2006/relationships/image" Target="../media/image18.png"/><Relationship Id="rId23" Type="http://schemas.openxmlformats.org/officeDocument/2006/relationships/image" Target="../media/image22.png"/><Relationship Id="rId10" Type="http://schemas.microsoft.com/office/2014/relationships/chartEx" Target="../charts/chartEx15.xml"/><Relationship Id="rId19" Type="http://schemas.openxmlformats.org/officeDocument/2006/relationships/image" Target="../media/image20.png"/><Relationship Id="rId4" Type="http://schemas.openxmlformats.org/officeDocument/2006/relationships/image" Target="../media/image13.png"/><Relationship Id="rId9" Type="http://schemas.openxmlformats.org/officeDocument/2006/relationships/image" Target="../media/image15.png"/><Relationship Id="rId14" Type="http://schemas.microsoft.com/office/2014/relationships/chartEx" Target="../charts/chartEx17.xml"/><Relationship Id="rId22" Type="http://schemas.microsoft.com/office/2014/relationships/chartEx" Target="../charts/chartEx2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4" name="Диаграмма 3"/>
              <p:cNvGraphicFramePr/>
              <p:nvPr>
                <p:extLst>
                  <p:ext uri="{D42A27DB-BD31-4B8C-83A1-F6EECF244321}">
                    <p14:modId xmlns:p14="http://schemas.microsoft.com/office/powerpoint/2010/main" val="2392492749"/>
                  </p:ext>
                </p:extLst>
              </p:nvPr>
            </p:nvGraphicFramePr>
            <p:xfrm>
              <a:off x="3426415" y="1951677"/>
              <a:ext cx="3268467" cy="185681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>
          <p:pic>
            <p:nvPicPr>
              <p:cNvPr id="4" name="Диаграмма 3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426415" y="1951677"/>
                <a:ext cx="3268467" cy="1856817"/>
              </a:xfrm>
              <a:prstGeom prst="rect">
                <a:avLst/>
              </a:prstGeom>
            </p:spPr>
          </p:pic>
        </mc:Fallback>
      </mc:AlternateContent>
      <p:sp>
        <p:nvSpPr>
          <p:cNvPr id="5" name="TextBox 6"/>
          <p:cNvSpPr txBox="1"/>
          <p:nvPr/>
        </p:nvSpPr>
        <p:spPr>
          <a:xfrm>
            <a:off x="5826441" y="2278697"/>
            <a:ext cx="243299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grpSp>
        <p:nvGrpSpPr>
          <p:cNvPr id="3" name="Группа 2"/>
          <p:cNvGrpSpPr/>
          <p:nvPr/>
        </p:nvGrpSpPr>
        <p:grpSpPr>
          <a:xfrm>
            <a:off x="130504" y="5773403"/>
            <a:ext cx="3036704" cy="1756745"/>
            <a:chOff x="130504" y="5773403"/>
            <a:chExt cx="3036704" cy="1756745"/>
          </a:xfrm>
        </p:grpSpPr>
        <mc:AlternateContent xmlns:mc="http://schemas.openxmlformats.org/markup-compatibility/2006">
          <mc:Choice xmlns:cx1="http://schemas.microsoft.com/office/drawing/2015/9/8/chartex" xmlns="" Requires="cx1">
            <p:graphicFrame>
              <p:nvGraphicFramePr>
                <p:cNvPr id="6" name="Диаграмма 5"/>
                <p:cNvGraphicFramePr/>
                <p:nvPr>
                  <p:extLst>
                    <p:ext uri="{D42A27DB-BD31-4B8C-83A1-F6EECF244321}">
                      <p14:modId xmlns:p14="http://schemas.microsoft.com/office/powerpoint/2010/main" val="284304881"/>
                    </p:ext>
                  </p:extLst>
                </p:nvPr>
              </p:nvGraphicFramePr>
              <p:xfrm>
                <a:off x="130504" y="5773403"/>
                <a:ext cx="3036704" cy="1756745"/>
              </p:xfrm>
              <a:graphic>
                <a:graphicData uri="http://schemas.microsoft.com/office/drawing/2014/chartex">
                  <cx:chart xmlns:cx="http://schemas.microsoft.com/office/drawing/2014/chartex" xmlns:r="http://schemas.openxmlformats.org/officeDocument/2006/relationships" r:id="rId4"/>
                </a:graphicData>
              </a:graphic>
            </p:graphicFrame>
          </mc:Choice>
          <mc:Fallback>
            <p:pic>
              <p:nvPicPr>
                <p:cNvPr id="6" name="Диаграмма 5"/>
                <p:cNvPicPr>
                  <a:picLocks noGrp="1" noRot="1" noChangeAspect="1" noMove="1" noResize="1" noEditPoints="1" noAdjustHandles="1" noChangeArrowheads="1" noChangeShapeType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30504" y="5773403"/>
                  <a:ext cx="3036704" cy="1756745"/>
                </a:xfrm>
                <a:prstGeom prst="rect">
                  <a:avLst/>
                </a:prstGeom>
              </p:spPr>
            </p:pic>
          </mc:Fallback>
        </mc:AlternateContent>
        <p:sp>
          <p:nvSpPr>
            <p:cNvPr id="7" name="TextBox 6"/>
            <p:cNvSpPr txBox="1"/>
            <p:nvPr/>
          </p:nvSpPr>
          <p:spPr>
            <a:xfrm>
              <a:off x="608885" y="5973444"/>
              <a:ext cx="261703" cy="307777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ru-RU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62243" y="6239237"/>
              <a:ext cx="243005" cy="307777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ru-RU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910859" y="6281221"/>
              <a:ext cx="243005" cy="307777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ru-RU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381120" y="6309464"/>
              <a:ext cx="243005" cy="307777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ru-RU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</p:grpSp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11" name="Диаграмма 10"/>
              <p:cNvGraphicFramePr/>
              <p:nvPr>
                <p:extLst>
                  <p:ext uri="{D42A27DB-BD31-4B8C-83A1-F6EECF244321}">
                    <p14:modId xmlns:p14="http://schemas.microsoft.com/office/powerpoint/2010/main" val="2678835223"/>
                  </p:ext>
                </p:extLst>
              </p:nvPr>
            </p:nvGraphicFramePr>
            <p:xfrm>
              <a:off x="-60844" y="7674692"/>
              <a:ext cx="3505304" cy="1884942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6"/>
              </a:graphicData>
            </a:graphic>
          </p:graphicFrame>
        </mc:Choice>
        <mc:Fallback>
          <p:pic>
            <p:nvPicPr>
              <p:cNvPr id="11" name="Диаграмма 10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-60844" y="7674692"/>
                <a:ext cx="3505304" cy="1884942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15" name="Диаграмма 14"/>
              <p:cNvGraphicFramePr/>
              <p:nvPr>
                <p:extLst>
                  <p:ext uri="{D42A27DB-BD31-4B8C-83A1-F6EECF244321}">
                    <p14:modId xmlns:p14="http://schemas.microsoft.com/office/powerpoint/2010/main" val="677468707"/>
                  </p:ext>
                </p:extLst>
              </p:nvPr>
            </p:nvGraphicFramePr>
            <p:xfrm>
              <a:off x="3232953" y="3848117"/>
              <a:ext cx="3687417" cy="196264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8"/>
              </a:graphicData>
            </a:graphic>
          </p:graphicFrame>
        </mc:Choice>
        <mc:Fallback>
          <p:pic>
            <p:nvPicPr>
              <p:cNvPr id="15" name="Диаграмма 14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232953" y="3848117"/>
                <a:ext cx="3687417" cy="1962647"/>
              </a:xfrm>
              <a:prstGeom prst="rect">
                <a:avLst/>
              </a:prstGeom>
            </p:spPr>
          </p:pic>
        </mc:Fallback>
      </mc:AlternateContent>
      <p:sp>
        <p:nvSpPr>
          <p:cNvPr id="16" name="TextBox 15"/>
          <p:cNvSpPr txBox="1"/>
          <p:nvPr/>
        </p:nvSpPr>
        <p:spPr>
          <a:xfrm>
            <a:off x="4849948" y="4487579"/>
            <a:ext cx="243299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394373" y="4243413"/>
            <a:ext cx="217034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48336" y="4529624"/>
            <a:ext cx="217034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grpSp>
        <p:nvGrpSpPr>
          <p:cNvPr id="38" name="Группа 37"/>
          <p:cNvGrpSpPr/>
          <p:nvPr/>
        </p:nvGrpSpPr>
        <p:grpSpPr>
          <a:xfrm>
            <a:off x="3358863" y="5754947"/>
            <a:ext cx="3401029" cy="1914250"/>
            <a:chOff x="3358863" y="5754947"/>
            <a:chExt cx="3401029" cy="1914250"/>
          </a:xfrm>
        </p:grpSpPr>
        <mc:AlternateContent xmlns:mc="http://schemas.openxmlformats.org/markup-compatibility/2006">
          <mc:Choice xmlns:cx1="http://schemas.microsoft.com/office/drawing/2015/9/8/chartex" xmlns="" Requires="cx1">
            <p:graphicFrame>
              <p:nvGraphicFramePr>
                <p:cNvPr id="19" name="Диаграмма 18"/>
                <p:cNvGraphicFramePr/>
                <p:nvPr>
                  <p:extLst>
                    <p:ext uri="{D42A27DB-BD31-4B8C-83A1-F6EECF244321}">
                      <p14:modId xmlns:p14="http://schemas.microsoft.com/office/powerpoint/2010/main" val="4259824864"/>
                    </p:ext>
                  </p:extLst>
                </p:nvPr>
              </p:nvGraphicFramePr>
              <p:xfrm>
                <a:off x="3358863" y="5754947"/>
                <a:ext cx="3401029" cy="1914250"/>
              </p:xfrm>
              <a:graphic>
                <a:graphicData uri="http://schemas.microsoft.com/office/drawing/2014/chartex">
                  <cx:chart xmlns:cx="http://schemas.microsoft.com/office/drawing/2014/chartex" xmlns:r="http://schemas.openxmlformats.org/officeDocument/2006/relationships" r:id="rId10"/>
                </a:graphicData>
              </a:graphic>
            </p:graphicFrame>
          </mc:Choice>
          <mc:Fallback>
            <p:pic>
              <p:nvPicPr>
                <p:cNvPr id="19" name="Диаграмма 18"/>
                <p:cNvPicPr>
                  <a:picLocks noGrp="1" noRot="1" noChangeAspect="1" noMove="1" noResize="1" noEditPoints="1" noAdjustHandles="1" noChangeArrowheads="1" noChangeShapeType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3358863" y="5754947"/>
                  <a:ext cx="3401029" cy="1914250"/>
                </a:xfrm>
                <a:prstGeom prst="rect">
                  <a:avLst/>
                </a:prstGeom>
              </p:spPr>
            </p:pic>
          </mc:Fallback>
        </mc:AlternateContent>
        <p:sp>
          <p:nvSpPr>
            <p:cNvPr id="20" name="TextBox 19"/>
            <p:cNvSpPr txBox="1"/>
            <p:nvPr/>
          </p:nvSpPr>
          <p:spPr>
            <a:xfrm>
              <a:off x="4044546" y="6134675"/>
              <a:ext cx="234090" cy="31422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ru-RU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502885" y="6134674"/>
              <a:ext cx="234090" cy="31422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squar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ru-RU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</p:grpSp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25" name="Диаграмма 24"/>
              <p:cNvGraphicFramePr/>
              <p:nvPr>
                <p:extLst>
                  <p:ext uri="{D42A27DB-BD31-4B8C-83A1-F6EECF244321}">
                    <p14:modId xmlns:p14="http://schemas.microsoft.com/office/powerpoint/2010/main" val="1964782744"/>
                  </p:ext>
                </p:extLst>
              </p:nvPr>
            </p:nvGraphicFramePr>
            <p:xfrm>
              <a:off x="70649" y="3826742"/>
              <a:ext cx="3179890" cy="182872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2"/>
              </a:graphicData>
            </a:graphic>
          </p:graphicFrame>
        </mc:Choice>
        <mc:Fallback>
          <p:pic>
            <p:nvPicPr>
              <p:cNvPr id="25" name="Диаграмма 24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70649" y="3826742"/>
                <a:ext cx="3179890" cy="1828720"/>
              </a:xfrm>
              <a:prstGeom prst="rect">
                <a:avLst/>
              </a:prstGeom>
            </p:spPr>
          </p:pic>
        </mc:Fallback>
      </mc:AlternateContent>
      <p:sp>
        <p:nvSpPr>
          <p:cNvPr id="26" name="TextBox 25"/>
          <p:cNvSpPr txBox="1"/>
          <p:nvPr/>
        </p:nvSpPr>
        <p:spPr>
          <a:xfrm>
            <a:off x="1038980" y="4197390"/>
            <a:ext cx="238665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453143" y="4222996"/>
            <a:ext cx="238665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28" name="Диаграмма 27"/>
              <p:cNvGraphicFramePr/>
              <p:nvPr>
                <p:extLst>
                  <p:ext uri="{D42A27DB-BD31-4B8C-83A1-F6EECF244321}">
                    <p14:modId xmlns:p14="http://schemas.microsoft.com/office/powerpoint/2010/main" val="2490243714"/>
                  </p:ext>
                </p:extLst>
              </p:nvPr>
            </p:nvGraphicFramePr>
            <p:xfrm>
              <a:off x="181908" y="1958146"/>
              <a:ext cx="3236731" cy="1811156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4"/>
              </a:graphicData>
            </a:graphic>
          </p:graphicFrame>
        </mc:Choice>
        <mc:Fallback>
          <p:pic>
            <p:nvPicPr>
              <p:cNvPr id="28" name="Диаграмма 2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81908" y="1958146"/>
                <a:ext cx="3236731" cy="1811156"/>
              </a:xfrm>
              <a:prstGeom prst="rect">
                <a:avLst/>
              </a:prstGeom>
            </p:spPr>
          </p:pic>
        </mc:Fallback>
      </mc:AlternateContent>
      <p:sp>
        <p:nvSpPr>
          <p:cNvPr id="29" name="TextBox 28"/>
          <p:cNvSpPr txBox="1"/>
          <p:nvPr/>
        </p:nvSpPr>
        <p:spPr>
          <a:xfrm>
            <a:off x="1235277" y="2264289"/>
            <a:ext cx="217034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678204" y="2335087"/>
            <a:ext cx="217034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161203" y="2424644"/>
            <a:ext cx="217034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807251" y="2274496"/>
            <a:ext cx="217034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33" name="Диаграмма 32"/>
              <p:cNvGraphicFramePr/>
              <p:nvPr>
                <p:extLst>
                  <p:ext uri="{D42A27DB-BD31-4B8C-83A1-F6EECF244321}">
                    <p14:modId xmlns:p14="http://schemas.microsoft.com/office/powerpoint/2010/main" val="2099857682"/>
                  </p:ext>
                </p:extLst>
              </p:nvPr>
            </p:nvGraphicFramePr>
            <p:xfrm>
              <a:off x="3544930" y="7717595"/>
              <a:ext cx="3149952" cy="1759958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6"/>
              </a:graphicData>
            </a:graphic>
          </p:graphicFrame>
        </mc:Choice>
        <mc:Fallback>
          <p:pic>
            <p:nvPicPr>
              <p:cNvPr id="33" name="Диаграмма 32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3544930" y="7717595"/>
                <a:ext cx="3149952" cy="1759958"/>
              </a:xfrm>
              <a:prstGeom prst="rect">
                <a:avLst/>
              </a:prstGeom>
            </p:spPr>
          </p:pic>
        </mc:Fallback>
      </mc:AlternateContent>
      <p:sp>
        <p:nvSpPr>
          <p:cNvPr id="35" name="TextBox 6"/>
          <p:cNvSpPr txBox="1"/>
          <p:nvPr/>
        </p:nvSpPr>
        <p:spPr>
          <a:xfrm>
            <a:off x="5419055" y="2272322"/>
            <a:ext cx="243299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4278636" y="9825620"/>
            <a:ext cx="217034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517304" y="9881538"/>
            <a:ext cx="217034" cy="307777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962222" y="2246963"/>
            <a:ext cx="2305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200" dirty="0" smtClean="0"/>
              <a:t>#</a:t>
            </a:r>
            <a:endParaRPr lang="ru-RU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5966567" y="8478280"/>
            <a:ext cx="238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200" dirty="0" smtClean="0"/>
              <a:t>#</a:t>
            </a:r>
            <a:endParaRPr lang="ru-RU" sz="1200" dirty="0"/>
          </a:p>
        </p:txBody>
      </p:sp>
      <p:pic>
        <p:nvPicPr>
          <p:cNvPr id="41" name="Рисунок 40"/>
          <p:cNvPicPr>
            <a:picLocks noChangeAspect="1"/>
          </p:cNvPicPr>
          <p:nvPr/>
        </p:nvPicPr>
        <p:blipFill rotWithShape="1">
          <a:blip r:embed="rId18"/>
          <a:srcRect l="57177" t="76117" r="26935" b="18506"/>
          <a:stretch/>
        </p:blipFill>
        <p:spPr>
          <a:xfrm>
            <a:off x="2202096" y="11423562"/>
            <a:ext cx="2223183" cy="423194"/>
          </a:xfrm>
          <a:prstGeom prst="rect">
            <a:avLst/>
          </a:prstGeom>
        </p:spPr>
      </p:pic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43" name="Диаграмма 42"/>
              <p:cNvGraphicFramePr/>
              <p:nvPr>
                <p:extLst>
                  <p:ext uri="{D42A27DB-BD31-4B8C-83A1-F6EECF244321}">
                    <p14:modId xmlns:p14="http://schemas.microsoft.com/office/powerpoint/2010/main" val="3212834844"/>
                  </p:ext>
                </p:extLst>
              </p:nvPr>
            </p:nvGraphicFramePr>
            <p:xfrm>
              <a:off x="235492" y="171031"/>
              <a:ext cx="3225800" cy="18034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9"/>
              </a:graphicData>
            </a:graphic>
          </p:graphicFrame>
        </mc:Choice>
        <mc:Fallback>
          <p:pic>
            <p:nvPicPr>
              <p:cNvPr id="43" name="Диаграмма 42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235492" y="171031"/>
                <a:ext cx="3225800" cy="18034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44" name="Диаграмма 43"/>
              <p:cNvGraphicFramePr/>
              <p:nvPr>
                <p:extLst>
                  <p:ext uri="{D42A27DB-BD31-4B8C-83A1-F6EECF244321}">
                    <p14:modId xmlns:p14="http://schemas.microsoft.com/office/powerpoint/2010/main" val="3932384147"/>
                  </p:ext>
                </p:extLst>
              </p:nvPr>
            </p:nvGraphicFramePr>
            <p:xfrm>
              <a:off x="3448710" y="190990"/>
              <a:ext cx="3397250" cy="1818839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1"/>
              </a:graphicData>
            </a:graphic>
          </p:graphicFrame>
        </mc:Choice>
        <mc:Fallback>
          <p:pic>
            <p:nvPicPr>
              <p:cNvPr id="44" name="Диаграмма 43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3448710" y="190990"/>
                <a:ext cx="3397250" cy="1818839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45" name="Диаграмма 44"/>
              <p:cNvGraphicFramePr/>
              <p:nvPr>
                <p:extLst>
                  <p:ext uri="{D42A27DB-BD31-4B8C-83A1-F6EECF244321}">
                    <p14:modId xmlns:p14="http://schemas.microsoft.com/office/powerpoint/2010/main" val="3734514065"/>
                  </p:ext>
                </p:extLst>
              </p:nvPr>
            </p:nvGraphicFramePr>
            <p:xfrm>
              <a:off x="1896533" y="9507763"/>
              <a:ext cx="3190316" cy="1915799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3"/>
              </a:graphicData>
            </a:graphic>
          </p:graphicFrame>
        </mc:Choice>
        <mc:Fallback>
          <p:pic>
            <p:nvPicPr>
              <p:cNvPr id="45" name="Диаграмма 44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1896533" y="9507763"/>
                <a:ext cx="3190316" cy="1915799"/>
              </a:xfrm>
              <a:prstGeom prst="rect">
                <a:avLst/>
              </a:prstGeom>
            </p:spPr>
          </p:pic>
        </mc:Fallback>
      </mc:AlternateContent>
    </p:spTree>
    <p:extLst>
      <p:ext uri="{BB962C8B-B14F-4D97-AF65-F5344CB8AC3E}">
        <p14:creationId xmlns:p14="http://schemas.microsoft.com/office/powerpoint/2010/main" val="751444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ru-RU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ru-RU" sz="1400" dirty="0" smtClean="0"/>
              <a:t>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or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multiplex analysis of blood serum of the studied groups</a:t>
            </a:r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* </a:t>
            </a:r>
            <a:r>
              <a:rPr lang="en-US" sz="1400" dirty="0"/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* P &lt;0,05 when comparing between groups; # P &lt;0,05, when comparing within-group scores one year later;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CL6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chemokine ligands 6; LIGHT – tumor necrosis factor ligand; CCL-15 – leukotactin-1; CCL-21 - 6Ckine/Exodus-2; CCL-8- monocyte chemotactic protein-2; sVCAM-1 – Serum Soluble Intercellular Adhesion Molecule-1.</a:t>
            </a:r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ru-R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ru-R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56912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020818" y="364794"/>
            <a:ext cx="3174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16" name="Диаграмма 15"/>
              <p:cNvGraphicFramePr/>
              <p:nvPr>
                <p:extLst>
                  <p:ext uri="{D42A27DB-BD31-4B8C-83A1-F6EECF244321}">
                    <p14:modId xmlns:p14="http://schemas.microsoft.com/office/powerpoint/2010/main" val="22948124"/>
                  </p:ext>
                </p:extLst>
              </p:nvPr>
            </p:nvGraphicFramePr>
            <p:xfrm>
              <a:off x="3358770" y="1887864"/>
              <a:ext cx="4163351" cy="1998295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3"/>
              </a:graphicData>
            </a:graphic>
          </p:graphicFrame>
        </mc:Choice>
        <mc:Fallback>
          <p:pic>
            <p:nvPicPr>
              <p:cNvPr id="16" name="Диаграмма 15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358770" y="1887864"/>
                <a:ext cx="4163351" cy="1998295"/>
              </a:xfrm>
              <a:prstGeom prst="rect">
                <a:avLst/>
              </a:prstGeom>
            </p:spPr>
          </p:pic>
        </mc:Fallback>
      </mc:AlternateContent>
      <p:sp>
        <p:nvSpPr>
          <p:cNvPr id="12" name="TextBox 11"/>
          <p:cNvSpPr txBox="1"/>
          <p:nvPr/>
        </p:nvSpPr>
        <p:spPr>
          <a:xfrm>
            <a:off x="4288451" y="2156879"/>
            <a:ext cx="3174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17316" y="7714112"/>
            <a:ext cx="3174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26" name="Диаграмма 25"/>
              <p:cNvGraphicFramePr/>
              <p:nvPr>
                <p:extLst>
                  <p:ext uri="{D42A27DB-BD31-4B8C-83A1-F6EECF244321}">
                    <p14:modId xmlns:p14="http://schemas.microsoft.com/office/powerpoint/2010/main" val="1261717337"/>
                  </p:ext>
                </p:extLst>
              </p:nvPr>
            </p:nvGraphicFramePr>
            <p:xfrm>
              <a:off x="3245637" y="174332"/>
              <a:ext cx="3383531" cy="1665529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5"/>
              </a:graphicData>
            </a:graphic>
          </p:graphicFrame>
        </mc:Choice>
        <mc:Fallback>
          <p:pic>
            <p:nvPicPr>
              <p:cNvPr id="26" name="Диаграмма 25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245637" y="174332"/>
                <a:ext cx="3383531" cy="1665529"/>
              </a:xfrm>
              <a:prstGeom prst="rect">
                <a:avLst/>
              </a:prstGeom>
            </p:spPr>
          </p:pic>
        </mc:Fallback>
      </mc:AlternateContent>
      <p:sp>
        <p:nvSpPr>
          <p:cNvPr id="27" name="TextBox 26"/>
          <p:cNvSpPr txBox="1"/>
          <p:nvPr/>
        </p:nvSpPr>
        <p:spPr>
          <a:xfrm>
            <a:off x="5246964" y="528347"/>
            <a:ext cx="3174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460004" y="7714112"/>
            <a:ext cx="3174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335825" y="7493147"/>
            <a:ext cx="3174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Рисунок 31"/>
          <p:cNvPicPr>
            <a:picLocks noChangeAspect="1"/>
          </p:cNvPicPr>
          <p:nvPr/>
        </p:nvPicPr>
        <p:blipFill rotWithShape="1">
          <a:blip r:embed="rId7"/>
          <a:srcRect l="57177" t="76117" r="26935" b="18506"/>
          <a:stretch/>
        </p:blipFill>
        <p:spPr>
          <a:xfrm>
            <a:off x="2107724" y="11803985"/>
            <a:ext cx="1905296" cy="362683"/>
          </a:xfrm>
          <a:prstGeom prst="rect">
            <a:avLst/>
          </a:prstGeom>
        </p:spPr>
      </p:pic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33" name="Диаграмма 32"/>
              <p:cNvGraphicFramePr/>
              <p:nvPr>
                <p:extLst>
                  <p:ext uri="{D42A27DB-BD31-4B8C-83A1-F6EECF244321}">
                    <p14:modId xmlns:p14="http://schemas.microsoft.com/office/powerpoint/2010/main" val="574916946"/>
                  </p:ext>
                </p:extLst>
              </p:nvPr>
            </p:nvGraphicFramePr>
            <p:xfrm>
              <a:off x="101441" y="48420"/>
              <a:ext cx="3257329" cy="1923681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8"/>
              </a:graphicData>
            </a:graphic>
          </p:graphicFrame>
        </mc:Choice>
        <mc:Fallback>
          <p:pic>
            <p:nvPicPr>
              <p:cNvPr id="33" name="Диаграмма 32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01441" y="48420"/>
                <a:ext cx="3257329" cy="1923681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34" name="Диаграмма 33"/>
              <p:cNvGraphicFramePr/>
              <p:nvPr>
                <p:extLst>
                  <p:ext uri="{D42A27DB-BD31-4B8C-83A1-F6EECF244321}">
                    <p14:modId xmlns:p14="http://schemas.microsoft.com/office/powerpoint/2010/main" val="558000050"/>
                  </p:ext>
                </p:extLst>
              </p:nvPr>
            </p:nvGraphicFramePr>
            <p:xfrm>
              <a:off x="-73486" y="1931773"/>
              <a:ext cx="3606421" cy="192023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0"/>
              </a:graphicData>
            </a:graphic>
          </p:graphicFrame>
        </mc:Choice>
        <mc:Fallback>
          <p:pic>
            <p:nvPicPr>
              <p:cNvPr id="34" name="Диаграмма 33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-73486" y="1931773"/>
                <a:ext cx="3606421" cy="1920234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35" name="Диаграмма 34"/>
              <p:cNvGraphicFramePr/>
              <p:nvPr>
                <p:extLst>
                  <p:ext uri="{D42A27DB-BD31-4B8C-83A1-F6EECF244321}">
                    <p14:modId xmlns:p14="http://schemas.microsoft.com/office/powerpoint/2010/main" val="10611861"/>
                  </p:ext>
                </p:extLst>
              </p:nvPr>
            </p:nvGraphicFramePr>
            <p:xfrm>
              <a:off x="66786" y="3874900"/>
              <a:ext cx="3258403" cy="173568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2"/>
              </a:graphicData>
            </a:graphic>
          </p:graphicFrame>
        </mc:Choice>
        <mc:Fallback>
          <p:pic>
            <p:nvPicPr>
              <p:cNvPr id="35" name="Диаграмма 34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66786" y="3874900"/>
                <a:ext cx="3258403" cy="1735687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36" name="Диаграмма 35"/>
              <p:cNvGraphicFramePr/>
              <p:nvPr>
                <p:extLst>
                  <p:ext uri="{D42A27DB-BD31-4B8C-83A1-F6EECF244321}">
                    <p14:modId xmlns:p14="http://schemas.microsoft.com/office/powerpoint/2010/main" val="1537024258"/>
                  </p:ext>
                </p:extLst>
              </p:nvPr>
            </p:nvGraphicFramePr>
            <p:xfrm>
              <a:off x="3532935" y="3930068"/>
              <a:ext cx="2801203" cy="174918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4"/>
              </a:graphicData>
            </a:graphic>
          </p:graphicFrame>
        </mc:Choice>
        <mc:Fallback>
          <p:pic>
            <p:nvPicPr>
              <p:cNvPr id="36" name="Диаграмма 35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3532935" y="3930068"/>
                <a:ext cx="2801203" cy="1749187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37" name="Диаграмма 36"/>
              <p:cNvGraphicFramePr/>
              <p:nvPr>
                <p:extLst>
                  <p:ext uri="{D42A27DB-BD31-4B8C-83A1-F6EECF244321}">
                    <p14:modId xmlns:p14="http://schemas.microsoft.com/office/powerpoint/2010/main" val="1974133956"/>
                  </p:ext>
                </p:extLst>
              </p:nvPr>
            </p:nvGraphicFramePr>
            <p:xfrm>
              <a:off x="101441" y="5566249"/>
              <a:ext cx="3145451" cy="165812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6"/>
              </a:graphicData>
            </a:graphic>
          </p:graphicFrame>
        </mc:Choice>
        <mc:Fallback>
          <p:pic>
            <p:nvPicPr>
              <p:cNvPr id="37" name="Диаграмма 36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101441" y="5566249"/>
                <a:ext cx="3145451" cy="1658127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38" name="Диаграмма 37"/>
              <p:cNvGraphicFramePr/>
              <p:nvPr>
                <p:extLst>
                  <p:ext uri="{D42A27DB-BD31-4B8C-83A1-F6EECF244321}">
                    <p14:modId xmlns:p14="http://schemas.microsoft.com/office/powerpoint/2010/main" val="3533713754"/>
                  </p:ext>
                </p:extLst>
              </p:nvPr>
            </p:nvGraphicFramePr>
            <p:xfrm>
              <a:off x="3462950" y="5577779"/>
              <a:ext cx="3130170" cy="1658795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8"/>
              </a:graphicData>
            </a:graphic>
          </p:graphicFrame>
        </mc:Choice>
        <mc:Fallback>
          <p:pic>
            <p:nvPicPr>
              <p:cNvPr id="38" name="Диаграмма 37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3462950" y="5577779"/>
                <a:ext cx="3130170" cy="1658795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39" name="Диаграмма 38"/>
              <p:cNvGraphicFramePr/>
              <p:nvPr>
                <p:extLst>
                  <p:ext uri="{D42A27DB-BD31-4B8C-83A1-F6EECF244321}">
                    <p14:modId xmlns:p14="http://schemas.microsoft.com/office/powerpoint/2010/main" val="2814497892"/>
                  </p:ext>
                </p:extLst>
              </p:nvPr>
            </p:nvGraphicFramePr>
            <p:xfrm>
              <a:off x="0" y="7269572"/>
              <a:ext cx="3462950" cy="1995701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0"/>
              </a:graphicData>
            </a:graphic>
          </p:graphicFrame>
        </mc:Choice>
        <mc:Fallback>
          <p:pic>
            <p:nvPicPr>
              <p:cNvPr id="39" name="Диаграмма 38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0" y="7269572"/>
                <a:ext cx="3462950" cy="1995701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40" name="Диаграмма 39"/>
              <p:cNvGraphicFramePr/>
              <p:nvPr>
                <p:extLst>
                  <p:ext uri="{D42A27DB-BD31-4B8C-83A1-F6EECF244321}">
                    <p14:modId xmlns:p14="http://schemas.microsoft.com/office/powerpoint/2010/main" val="2533688528"/>
                  </p:ext>
                </p:extLst>
              </p:nvPr>
            </p:nvGraphicFramePr>
            <p:xfrm>
              <a:off x="3325189" y="7235420"/>
              <a:ext cx="3394881" cy="1958396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2"/>
              </a:graphicData>
            </a:graphic>
          </p:graphicFrame>
        </mc:Choice>
        <mc:Fallback>
          <p:pic>
            <p:nvPicPr>
              <p:cNvPr id="40" name="Диаграмма 39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3325189" y="7235420"/>
                <a:ext cx="3394881" cy="1958396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xmlns="" Requires="cx1">
          <p:graphicFrame>
            <p:nvGraphicFramePr>
              <p:cNvPr id="41" name="Диаграмма 40"/>
              <p:cNvGraphicFramePr/>
              <p:nvPr>
                <p:extLst>
                  <p:ext uri="{D42A27DB-BD31-4B8C-83A1-F6EECF244321}">
                    <p14:modId xmlns:p14="http://schemas.microsoft.com/office/powerpoint/2010/main" val="867235673"/>
                  </p:ext>
                </p:extLst>
              </p:nvPr>
            </p:nvGraphicFramePr>
            <p:xfrm>
              <a:off x="1729724" y="9265273"/>
              <a:ext cx="3367585" cy="1890092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4"/>
              </a:graphicData>
            </a:graphic>
          </p:graphicFrame>
        </mc:Choice>
        <mc:Fallback>
          <p:pic>
            <p:nvPicPr>
              <p:cNvPr id="41" name="Диаграмма 40"/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1729724" y="9265273"/>
                <a:ext cx="3367585" cy="1890092"/>
              </a:xfrm>
              <a:prstGeom prst="rect">
                <a:avLst/>
              </a:prstGeom>
            </p:spPr>
          </p:pic>
        </mc:Fallback>
      </mc:AlternateContent>
      <p:sp>
        <p:nvSpPr>
          <p:cNvPr id="42" name="TextBox 41"/>
          <p:cNvSpPr txBox="1"/>
          <p:nvPr/>
        </p:nvSpPr>
        <p:spPr>
          <a:xfrm>
            <a:off x="2535851" y="9871765"/>
            <a:ext cx="3174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532935" y="9533211"/>
            <a:ext cx="3174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ru-RU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ru-RU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55989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ru-RU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ynamics 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laboratory biomarkers of the studied </a:t>
            </a:r>
            <a:r>
              <a:rPr lang="en-US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ru-RU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ru-RU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ru-RU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ru-RU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* </a:t>
            </a:r>
            <a:r>
              <a:rPr lang="el-G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the difference between the indicators after 1 year and 1 day; </a:t>
            </a:r>
            <a:r>
              <a:rPr lang="el-GR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the difference between the indicators after 1 year and 7 day; CXCL6 – chemokine ligands 6; LIGHT – tumor necrosis factor ligand; CCL-15 – leukotactin-1; CCL-21 - 6Ckine/Exodus-2; CCL-8- monocyte chemotactic protein-2; sVCAM-1 – Serum Soluble Intercellular Adhesion Molecule-1.</a:t>
            </a:r>
            <a:r>
              <a:rPr lang="ru-RU" sz="1800" dirty="0"/>
              <a:t/>
            </a:r>
            <a:br>
              <a:rPr lang="ru-RU" sz="1800" dirty="0"/>
            </a:br>
            <a:endParaRPr lang="ru-RU" sz="1800" dirty="0"/>
          </a:p>
        </p:txBody>
      </p:sp>
    </p:spTree>
    <p:extLst>
      <p:ext uri="{BB962C8B-B14F-4D97-AF65-F5344CB8AC3E}">
        <p14:creationId xmlns:p14="http://schemas.microsoft.com/office/powerpoint/2010/main" val="41917461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5</TotalTime>
  <Words>55</Words>
  <Application>Microsoft Office PowerPoint</Application>
  <PresentationFormat>Произвольный</PresentationFormat>
  <Paragraphs>32</Paragraphs>
  <Slides>4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4</vt:i4>
      </vt:variant>
    </vt:vector>
  </HeadingPairs>
  <TitlesOfParts>
    <vt:vector size="5" baseType="lpstr">
      <vt:lpstr>Тема Office</vt:lpstr>
      <vt:lpstr>Презентация PowerPoint</vt:lpstr>
      <vt:lpstr>Figure 1. Indicators of multiplex analysis of blood serum of the studied groups   Note:*  :* P &lt;0,05 when comparing between groups; # P &lt;0,05, when comparing within-group scores one year later; CXCL6 – chemokine ligands 6; LIGHT – tumor necrosis factor ligand; CCL-15 – leukotactin-1; CCL-21 - 6Ckine/Exodus-2; CCL-8- monocyte chemotactic protein-2; sVCAM-1 – Serum Soluble Intercellular Adhesion Molecule-1.  </vt:lpstr>
      <vt:lpstr>Презентация PowerPoint</vt:lpstr>
      <vt:lpstr>Figure 2. Dynamics of laboratory biomarkers of the studied groups  Note:* Δ1 – the difference between the indicators after 1 year and 1 day; Δ2 – the difference between the indicators after 1 year and 7 day; CXCL6 – chemokine ligands 6; LIGHT – tumor necrosis factor ligand; CCL-15 – leukotactin-1; CCL-21 - 6Ckine/Exodus-2; CCL-8- monocyte chemotactic protein-2; sVCAM-1 – Serum Soluble Intercellular Adhesion Molecule-1. </vt:lpstr>
    </vt:vector>
  </TitlesOfParts>
  <Company>diakov.ne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RePack by Diakov</dc:creator>
  <cp:lastModifiedBy>Дарья А. Липнягова</cp:lastModifiedBy>
  <cp:revision>31</cp:revision>
  <dcterms:created xsi:type="dcterms:W3CDTF">2023-07-05T15:57:13Z</dcterms:created>
  <dcterms:modified xsi:type="dcterms:W3CDTF">2023-11-20T05:08:46Z</dcterms:modified>
</cp:coreProperties>
</file>